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72" r:id="rId2"/>
    <p:sldId id="277" r:id="rId3"/>
    <p:sldId id="275" r:id="rId4"/>
    <p:sldId id="261" r:id="rId5"/>
    <p:sldId id="276" r:id="rId6"/>
    <p:sldId id="271" r:id="rId7"/>
    <p:sldId id="279" r:id="rId8"/>
    <p:sldId id="278" r:id="rId9"/>
  </p:sldIdLst>
  <p:sldSz cx="7559675" cy="10691813"/>
  <p:notesSz cx="6865938" cy="9998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066"/>
    <p:restoredTop sz="96366" autoAdjust="0"/>
  </p:normalViewPr>
  <p:slideViewPr>
    <p:cSldViewPr snapToGrid="0">
      <p:cViewPr varScale="1">
        <p:scale>
          <a:sx n="82" d="100"/>
          <a:sy n="82" d="100"/>
        </p:scale>
        <p:origin x="16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achel\AppData\Roaming\Microsoft\Excel\New%2520Microsoft%2520Excel%2520Worksheet%20(version%201).xlsb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technionmail-my.sharepoint.com/personal/rachelev_campus_technion_ac_il/Documents/Reserch%20staff/Results/in_vivo_Results_2020-2022/H&amp;E_exp/Draft/Supplementar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technionmail-my.sharepoint.com/personal/rachelev_campus_technion_ac_il/Documents/Reserch%20staff/Results/in_vivo_Results_2020-2022/H&amp;E_exp/Draft/Supplementar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267431495843366"/>
          <c:y val="5.6404230317273797E-2"/>
          <c:w val="0.7334220244122801"/>
          <c:h val="0.72044813335890767"/>
        </c:manualLayout>
      </c:layout>
      <c:scatterChart>
        <c:scatterStyle val="lineMarker"/>
        <c:varyColors val="0"/>
        <c:ser>
          <c:idx val="0"/>
          <c:order val="0"/>
          <c:tx>
            <c:v>PF+1.5%PEG-DA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S$2:$S$28</c:f>
                <c:numCache>
                  <c:formatCode>General</c:formatCode>
                  <c:ptCount val="27"/>
                  <c:pt idx="0">
                    <c:v>4.4820605380412548E-2</c:v>
                  </c:pt>
                  <c:pt idx="1">
                    <c:v>3.686392394861001E-2</c:v>
                  </c:pt>
                  <c:pt idx="2">
                    <c:v>0.10438371935635683</c:v>
                  </c:pt>
                  <c:pt idx="3">
                    <c:v>1.9973148641780712E-2</c:v>
                  </c:pt>
                  <c:pt idx="4">
                    <c:v>4.1896883999754428E-2</c:v>
                  </c:pt>
                  <c:pt idx="5">
                    <c:v>5.8840858819927899E-2</c:v>
                  </c:pt>
                  <c:pt idx="6">
                    <c:v>5.9084252461115969E-2</c:v>
                  </c:pt>
                  <c:pt idx="7">
                    <c:v>3.7480335584884734E-2</c:v>
                  </c:pt>
                  <c:pt idx="8">
                    <c:v>8.2182980124976227E-2</c:v>
                  </c:pt>
                  <c:pt idx="9">
                    <c:v>0.79567120512600353</c:v>
                  </c:pt>
                  <c:pt idx="10">
                    <c:v>3.0637520932492017</c:v>
                  </c:pt>
                  <c:pt idx="11">
                    <c:v>7.555749834103576</c:v>
                  </c:pt>
                  <c:pt idx="12">
                    <c:v>15.030647210135623</c:v>
                  </c:pt>
                  <c:pt idx="13">
                    <c:v>24.141573178970024</c:v>
                  </c:pt>
                  <c:pt idx="14">
                    <c:v>34.295480751842511</c:v>
                  </c:pt>
                  <c:pt idx="15">
                    <c:v>43.728734514301017</c:v>
                  </c:pt>
                  <c:pt idx="16">
                    <c:v>52.056144903577156</c:v>
                  </c:pt>
                  <c:pt idx="17">
                    <c:v>55.196799424121217</c:v>
                  </c:pt>
                  <c:pt idx="18">
                    <c:v>53.124591501697424</c:v>
                  </c:pt>
                  <c:pt idx="19">
                    <c:v>43.706089074890031</c:v>
                  </c:pt>
                  <c:pt idx="20">
                    <c:v>28.755675768252935</c:v>
                  </c:pt>
                  <c:pt idx="21">
                    <c:v>20.038851153585515</c:v>
                  </c:pt>
                  <c:pt idx="22">
                    <c:v>22.425184255405547</c:v>
                  </c:pt>
                  <c:pt idx="23">
                    <c:v>17.5</c:v>
                  </c:pt>
                  <c:pt idx="24">
                    <c:v>17.5</c:v>
                  </c:pt>
                  <c:pt idx="25">
                    <c:v>16.5</c:v>
                  </c:pt>
                  <c:pt idx="26">
                    <c:v>0</c:v>
                  </c:pt>
                </c:numCache>
              </c:numRef>
            </c:plus>
            <c:minus>
              <c:numRef>
                <c:f>Sheet2!$S$2:$S$28</c:f>
                <c:numCache>
                  <c:formatCode>General</c:formatCode>
                  <c:ptCount val="27"/>
                  <c:pt idx="0">
                    <c:v>4.4820605380412548E-2</c:v>
                  </c:pt>
                  <c:pt idx="1">
                    <c:v>3.686392394861001E-2</c:v>
                  </c:pt>
                  <c:pt idx="2">
                    <c:v>0.10438371935635683</c:v>
                  </c:pt>
                  <c:pt idx="3">
                    <c:v>1.9973148641780712E-2</c:v>
                  </c:pt>
                  <c:pt idx="4">
                    <c:v>4.1896883999754428E-2</c:v>
                  </c:pt>
                  <c:pt idx="5">
                    <c:v>5.8840858819927899E-2</c:v>
                  </c:pt>
                  <c:pt idx="6">
                    <c:v>5.9084252461115969E-2</c:v>
                  </c:pt>
                  <c:pt idx="7">
                    <c:v>3.7480335584884734E-2</c:v>
                  </c:pt>
                  <c:pt idx="8">
                    <c:v>8.2182980124976227E-2</c:v>
                  </c:pt>
                  <c:pt idx="9">
                    <c:v>0.79567120512600353</c:v>
                  </c:pt>
                  <c:pt idx="10">
                    <c:v>3.0637520932492017</c:v>
                  </c:pt>
                  <c:pt idx="11">
                    <c:v>7.555749834103576</c:v>
                  </c:pt>
                  <c:pt idx="12">
                    <c:v>15.030647210135623</c:v>
                  </c:pt>
                  <c:pt idx="13">
                    <c:v>24.141573178970024</c:v>
                  </c:pt>
                  <c:pt idx="14">
                    <c:v>34.295480751842511</c:v>
                  </c:pt>
                  <c:pt idx="15">
                    <c:v>43.728734514301017</c:v>
                  </c:pt>
                  <c:pt idx="16">
                    <c:v>52.056144903577156</c:v>
                  </c:pt>
                  <c:pt idx="17">
                    <c:v>55.196799424121217</c:v>
                  </c:pt>
                  <c:pt idx="18">
                    <c:v>53.124591501697424</c:v>
                  </c:pt>
                  <c:pt idx="19">
                    <c:v>43.706089074890031</c:v>
                  </c:pt>
                  <c:pt idx="20">
                    <c:v>28.755675768252935</c:v>
                  </c:pt>
                  <c:pt idx="21">
                    <c:v>20.038851153585515</c:v>
                  </c:pt>
                  <c:pt idx="22">
                    <c:v>22.425184255405547</c:v>
                  </c:pt>
                  <c:pt idx="23">
                    <c:v>17.5</c:v>
                  </c:pt>
                  <c:pt idx="24">
                    <c:v>17.5</c:v>
                  </c:pt>
                  <c:pt idx="25">
                    <c:v>16.5</c:v>
                  </c:pt>
                  <c:pt idx="2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Z$2:$Z$38</c:f>
              <c:numCache>
                <c:formatCode>0</c:formatCode>
                <c:ptCount val="37"/>
                <c:pt idx="0">
                  <c:v>5.4736666666666665</c:v>
                </c:pt>
                <c:pt idx="1">
                  <c:v>10.937666666666667</c:v>
                </c:pt>
                <c:pt idx="2">
                  <c:v>16.458333333333332</c:v>
                </c:pt>
                <c:pt idx="3">
                  <c:v>21.901</c:v>
                </c:pt>
                <c:pt idx="4">
                  <c:v>27.380000000000006</c:v>
                </c:pt>
                <c:pt idx="5">
                  <c:v>32.869666666666667</c:v>
                </c:pt>
                <c:pt idx="6">
                  <c:v>38.327999999999996</c:v>
                </c:pt>
                <c:pt idx="7">
                  <c:v>43.734000000000002</c:v>
                </c:pt>
                <c:pt idx="8">
                  <c:v>49.229333333333329</c:v>
                </c:pt>
                <c:pt idx="9">
                  <c:v>54.729000000000006</c:v>
                </c:pt>
                <c:pt idx="10">
                  <c:v>60.156000000000006</c:v>
                </c:pt>
                <c:pt idx="11">
                  <c:v>65.640333333333331</c:v>
                </c:pt>
                <c:pt idx="12">
                  <c:v>71.12466666666667</c:v>
                </c:pt>
                <c:pt idx="13">
                  <c:v>76.63033333333334</c:v>
                </c:pt>
                <c:pt idx="14">
                  <c:v>82.072666666666677</c:v>
                </c:pt>
                <c:pt idx="15">
                  <c:v>87.510333333333335</c:v>
                </c:pt>
                <c:pt idx="16">
                  <c:v>93.031333333333336</c:v>
                </c:pt>
                <c:pt idx="17">
                  <c:v>98.536333333333346</c:v>
                </c:pt>
                <c:pt idx="18">
                  <c:v>103.92666666666666</c:v>
                </c:pt>
                <c:pt idx="19">
                  <c:v>109.33999999999999</c:v>
                </c:pt>
                <c:pt idx="20">
                  <c:v>114.80333333333334</c:v>
                </c:pt>
                <c:pt idx="21">
                  <c:v>120.3</c:v>
                </c:pt>
                <c:pt idx="22">
                  <c:v>125.75999999999999</c:v>
                </c:pt>
                <c:pt idx="23">
                  <c:v>131.16333333333333</c:v>
                </c:pt>
                <c:pt idx="24">
                  <c:v>136.68666666666667</c:v>
                </c:pt>
                <c:pt idx="25">
                  <c:v>142.13</c:v>
                </c:pt>
                <c:pt idx="26">
                  <c:v>147.55000000000001</c:v>
                </c:pt>
                <c:pt idx="27">
                  <c:v>152.98333333333335</c:v>
                </c:pt>
                <c:pt idx="28">
                  <c:v>158.44</c:v>
                </c:pt>
                <c:pt idx="29">
                  <c:v>163.90333333333334</c:v>
                </c:pt>
                <c:pt idx="30">
                  <c:v>169.35333333333335</c:v>
                </c:pt>
                <c:pt idx="31">
                  <c:v>174.84</c:v>
                </c:pt>
                <c:pt idx="32">
                  <c:v>180.35333333333335</c:v>
                </c:pt>
              </c:numCache>
            </c:numRef>
          </c:xVal>
          <c:yVal>
            <c:numRef>
              <c:f>Sheet2!$AA$2:$AA$38</c:f>
              <c:numCache>
                <c:formatCode>General</c:formatCode>
                <c:ptCount val="37"/>
                <c:pt idx="0">
                  <c:v>0.17190000000000003</c:v>
                </c:pt>
                <c:pt idx="1">
                  <c:v>0.24506666666666665</c:v>
                </c:pt>
                <c:pt idx="2">
                  <c:v>0.21089000000000002</c:v>
                </c:pt>
                <c:pt idx="3">
                  <c:v>0.23480000000000001</c:v>
                </c:pt>
                <c:pt idx="4">
                  <c:v>0.26666666666666666</c:v>
                </c:pt>
                <c:pt idx="5">
                  <c:v>0.27060000000000001</c:v>
                </c:pt>
                <c:pt idx="6">
                  <c:v>0.25636666666666669</c:v>
                </c:pt>
                <c:pt idx="7">
                  <c:v>0.29563333333333336</c:v>
                </c:pt>
                <c:pt idx="8">
                  <c:v>0.37633333333333335</c:v>
                </c:pt>
                <c:pt idx="9">
                  <c:v>2.2360000000000002</c:v>
                </c:pt>
                <c:pt idx="10">
                  <c:v>11.758666666666668</c:v>
                </c:pt>
                <c:pt idx="11">
                  <c:v>41.166666666666664</c:v>
                </c:pt>
                <c:pt idx="12">
                  <c:v>103.11333333333333</c:v>
                </c:pt>
                <c:pt idx="13">
                  <c:v>201.43333333333331</c:v>
                </c:pt>
                <c:pt idx="14">
                  <c:v>346.3</c:v>
                </c:pt>
                <c:pt idx="15">
                  <c:v>529.33333333333326</c:v>
                </c:pt>
                <c:pt idx="16">
                  <c:v>741.33333333333337</c:v>
                </c:pt>
                <c:pt idx="17">
                  <c:v>965.1</c:v>
                </c:pt>
                <c:pt idx="18">
                  <c:v>1193.3333333333333</c:v>
                </c:pt>
                <c:pt idx="19">
                  <c:v>1392.6666666666667</c:v>
                </c:pt>
                <c:pt idx="20">
                  <c:v>1537.6666666666667</c:v>
                </c:pt>
                <c:pt idx="21">
                  <c:v>1628.3333333333333</c:v>
                </c:pt>
                <c:pt idx="22">
                  <c:v>1666.6666666666667</c:v>
                </c:pt>
                <c:pt idx="23">
                  <c:v>1664.5</c:v>
                </c:pt>
                <c:pt idx="24">
                  <c:v>1658.5</c:v>
                </c:pt>
                <c:pt idx="25">
                  <c:v>1658</c:v>
                </c:pt>
                <c:pt idx="26">
                  <c:v>164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35D-4341-A9A9-83854E52BD4E}"/>
            </c:ext>
          </c:extLst>
        </c:ser>
        <c:ser>
          <c:idx val="1"/>
          <c:order val="1"/>
          <c:tx>
            <c:v>PF+3%PEG-DA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W$2:$W$38</c:f>
                <c:numCache>
                  <c:formatCode>General</c:formatCode>
                  <c:ptCount val="37"/>
                  <c:pt idx="0">
                    <c:v>5.0274156603788214E-2</c:v>
                  </c:pt>
                  <c:pt idx="1">
                    <c:v>5.0157441012165759E-3</c:v>
                  </c:pt>
                  <c:pt idx="2">
                    <c:v>9.8169999943408959E-3</c:v>
                  </c:pt>
                  <c:pt idx="3">
                    <c:v>8.5324218263176696E-4</c:v>
                  </c:pt>
                  <c:pt idx="4">
                    <c:v>1.1432947515356166E-2</c:v>
                  </c:pt>
                  <c:pt idx="5">
                    <c:v>1.4548486748341447E-2</c:v>
                  </c:pt>
                  <c:pt idx="6">
                    <c:v>1.365496816384263E-2</c:v>
                  </c:pt>
                  <c:pt idx="7">
                    <c:v>0.12261397754289226</c:v>
                  </c:pt>
                  <c:pt idx="8">
                    <c:v>0.12797689930434925</c:v>
                  </c:pt>
                  <c:pt idx="9">
                    <c:v>0.96496505405924138</c:v>
                  </c:pt>
                  <c:pt idx="10">
                    <c:v>3.3275850646110037</c:v>
                  </c:pt>
                  <c:pt idx="11">
                    <c:v>6.0851380095734493</c:v>
                  </c:pt>
                  <c:pt idx="12">
                    <c:v>3.1684554947516941</c:v>
                  </c:pt>
                  <c:pt idx="13">
                    <c:v>6.5457851876014255</c:v>
                  </c:pt>
                  <c:pt idx="14">
                    <c:v>26.304826931667893</c:v>
                  </c:pt>
                  <c:pt idx="15">
                    <c:v>50.536429333637045</c:v>
                  </c:pt>
                  <c:pt idx="16">
                    <c:v>77.034252945614398</c:v>
                  </c:pt>
                  <c:pt idx="17">
                    <c:v>101.19921807291246</c:v>
                  </c:pt>
                  <c:pt idx="18">
                    <c:v>123.98463255541883</c:v>
                  </c:pt>
                  <c:pt idx="19">
                    <c:v>136.30221466946995</c:v>
                  </c:pt>
                  <c:pt idx="20">
                    <c:v>135.64431082703851</c:v>
                  </c:pt>
                  <c:pt idx="21">
                    <c:v>128.2409482239932</c:v>
                  </c:pt>
                  <c:pt idx="22">
                    <c:v>112.13300133943127</c:v>
                  </c:pt>
                  <c:pt idx="23">
                    <c:v>93.820602097833628</c:v>
                  </c:pt>
                  <c:pt idx="24">
                    <c:v>73.368665207309135</c:v>
                  </c:pt>
                  <c:pt idx="25">
                    <c:v>49.79060573276405</c:v>
                  </c:pt>
                  <c:pt idx="26">
                    <c:v>32.63812479349199</c:v>
                  </c:pt>
                  <c:pt idx="27">
                    <c:v>20.961658844662161</c:v>
                  </c:pt>
                  <c:pt idx="28">
                    <c:v>21.399671172759241</c:v>
                  </c:pt>
                  <c:pt idx="29">
                    <c:v>24.712545155626728</c:v>
                  </c:pt>
                  <c:pt idx="30">
                    <c:v>30.321017669267007</c:v>
                  </c:pt>
                  <c:pt idx="31">
                    <c:v>32.666164078990811</c:v>
                  </c:pt>
                  <c:pt idx="32">
                    <c:v>35.994755088330294</c:v>
                  </c:pt>
                  <c:pt idx="33">
                    <c:v>40.330760502403429</c:v>
                  </c:pt>
                  <c:pt idx="34">
                    <c:v>39.988974396450878</c:v>
                  </c:pt>
                  <c:pt idx="35">
                    <c:v>39.634981643857174</c:v>
                  </c:pt>
                  <c:pt idx="36">
                    <c:v>39.342022124469281</c:v>
                  </c:pt>
                </c:numCache>
              </c:numRef>
            </c:plus>
            <c:minus>
              <c:numRef>
                <c:f>Sheet2!$W$2:$W$38</c:f>
                <c:numCache>
                  <c:formatCode>General</c:formatCode>
                  <c:ptCount val="37"/>
                  <c:pt idx="0">
                    <c:v>5.0274156603788214E-2</c:v>
                  </c:pt>
                  <c:pt idx="1">
                    <c:v>5.0157441012165759E-3</c:v>
                  </c:pt>
                  <c:pt idx="2">
                    <c:v>9.8169999943408959E-3</c:v>
                  </c:pt>
                  <c:pt idx="3">
                    <c:v>8.5324218263176696E-4</c:v>
                  </c:pt>
                  <c:pt idx="4">
                    <c:v>1.1432947515356166E-2</c:v>
                  </c:pt>
                  <c:pt idx="5">
                    <c:v>1.4548486748341447E-2</c:v>
                  </c:pt>
                  <c:pt idx="6">
                    <c:v>1.365496816384263E-2</c:v>
                  </c:pt>
                  <c:pt idx="7">
                    <c:v>0.12261397754289226</c:v>
                  </c:pt>
                  <c:pt idx="8">
                    <c:v>0.12797689930434925</c:v>
                  </c:pt>
                  <c:pt idx="9">
                    <c:v>0.96496505405924138</c:v>
                  </c:pt>
                  <c:pt idx="10">
                    <c:v>3.3275850646110037</c:v>
                  </c:pt>
                  <c:pt idx="11">
                    <c:v>6.0851380095734493</c:v>
                  </c:pt>
                  <c:pt idx="12">
                    <c:v>3.1684554947516941</c:v>
                  </c:pt>
                  <c:pt idx="13">
                    <c:v>6.5457851876014255</c:v>
                  </c:pt>
                  <c:pt idx="14">
                    <c:v>26.304826931667893</c:v>
                  </c:pt>
                  <c:pt idx="15">
                    <c:v>50.536429333637045</c:v>
                  </c:pt>
                  <c:pt idx="16">
                    <c:v>77.034252945614398</c:v>
                  </c:pt>
                  <c:pt idx="17">
                    <c:v>101.19921807291246</c:v>
                  </c:pt>
                  <c:pt idx="18">
                    <c:v>123.98463255541883</c:v>
                  </c:pt>
                  <c:pt idx="19">
                    <c:v>136.30221466946995</c:v>
                  </c:pt>
                  <c:pt idx="20">
                    <c:v>135.64431082703851</c:v>
                  </c:pt>
                  <c:pt idx="21">
                    <c:v>128.2409482239932</c:v>
                  </c:pt>
                  <c:pt idx="22">
                    <c:v>112.13300133943127</c:v>
                  </c:pt>
                  <c:pt idx="23">
                    <c:v>93.820602097833628</c:v>
                  </c:pt>
                  <c:pt idx="24">
                    <c:v>73.368665207309135</c:v>
                  </c:pt>
                  <c:pt idx="25">
                    <c:v>49.79060573276405</c:v>
                  </c:pt>
                  <c:pt idx="26">
                    <c:v>32.63812479349199</c:v>
                  </c:pt>
                  <c:pt idx="27">
                    <c:v>20.961658844662161</c:v>
                  </c:pt>
                  <c:pt idx="28">
                    <c:v>21.399671172759241</c:v>
                  </c:pt>
                  <c:pt idx="29">
                    <c:v>24.712545155626728</c:v>
                  </c:pt>
                  <c:pt idx="30">
                    <c:v>30.321017669267007</c:v>
                  </c:pt>
                  <c:pt idx="31">
                    <c:v>32.666164078990811</c:v>
                  </c:pt>
                  <c:pt idx="32">
                    <c:v>35.994755088330294</c:v>
                  </c:pt>
                  <c:pt idx="33">
                    <c:v>40.330760502403429</c:v>
                  </c:pt>
                  <c:pt idx="34">
                    <c:v>39.988974396450878</c:v>
                  </c:pt>
                  <c:pt idx="35">
                    <c:v>39.634981643857174</c:v>
                  </c:pt>
                  <c:pt idx="36">
                    <c:v>39.3420221244692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Z$2:$Z$38</c:f>
              <c:numCache>
                <c:formatCode>0</c:formatCode>
                <c:ptCount val="37"/>
                <c:pt idx="0">
                  <c:v>5.4736666666666665</c:v>
                </c:pt>
                <c:pt idx="1">
                  <c:v>10.937666666666667</c:v>
                </c:pt>
                <c:pt idx="2">
                  <c:v>16.458333333333332</c:v>
                </c:pt>
                <c:pt idx="3">
                  <c:v>21.901</c:v>
                </c:pt>
                <c:pt idx="4">
                  <c:v>27.380000000000006</c:v>
                </c:pt>
                <c:pt idx="5">
                  <c:v>32.869666666666667</c:v>
                </c:pt>
                <c:pt idx="6">
                  <c:v>38.327999999999996</c:v>
                </c:pt>
                <c:pt idx="7">
                  <c:v>43.734000000000002</c:v>
                </c:pt>
                <c:pt idx="8">
                  <c:v>49.229333333333329</c:v>
                </c:pt>
                <c:pt idx="9">
                  <c:v>54.729000000000006</c:v>
                </c:pt>
                <c:pt idx="10">
                  <c:v>60.156000000000006</c:v>
                </c:pt>
                <c:pt idx="11">
                  <c:v>65.640333333333331</c:v>
                </c:pt>
                <c:pt idx="12">
                  <c:v>71.12466666666667</c:v>
                </c:pt>
                <c:pt idx="13">
                  <c:v>76.63033333333334</c:v>
                </c:pt>
                <c:pt idx="14">
                  <c:v>82.072666666666677</c:v>
                </c:pt>
                <c:pt idx="15">
                  <c:v>87.510333333333335</c:v>
                </c:pt>
                <c:pt idx="16">
                  <c:v>93.031333333333336</c:v>
                </c:pt>
                <c:pt idx="17">
                  <c:v>98.536333333333346</c:v>
                </c:pt>
                <c:pt idx="18">
                  <c:v>103.92666666666666</c:v>
                </c:pt>
                <c:pt idx="19">
                  <c:v>109.33999999999999</c:v>
                </c:pt>
                <c:pt idx="20">
                  <c:v>114.80333333333334</c:v>
                </c:pt>
                <c:pt idx="21">
                  <c:v>120.3</c:v>
                </c:pt>
                <c:pt idx="22">
                  <c:v>125.75999999999999</c:v>
                </c:pt>
                <c:pt idx="23">
                  <c:v>131.16333333333333</c:v>
                </c:pt>
                <c:pt idx="24">
                  <c:v>136.68666666666667</c:v>
                </c:pt>
                <c:pt idx="25">
                  <c:v>142.13</c:v>
                </c:pt>
                <c:pt idx="26">
                  <c:v>147.55000000000001</c:v>
                </c:pt>
                <c:pt idx="27">
                  <c:v>152.98333333333335</c:v>
                </c:pt>
                <c:pt idx="28">
                  <c:v>158.44</c:v>
                </c:pt>
                <c:pt idx="29">
                  <c:v>163.90333333333334</c:v>
                </c:pt>
                <c:pt idx="30">
                  <c:v>169.35333333333335</c:v>
                </c:pt>
                <c:pt idx="31">
                  <c:v>174.84</c:v>
                </c:pt>
                <c:pt idx="32">
                  <c:v>180.35333333333335</c:v>
                </c:pt>
              </c:numCache>
            </c:numRef>
          </c:xVal>
          <c:yVal>
            <c:numRef>
              <c:f>Sheet2!$AB$2:$AB$38</c:f>
              <c:numCache>
                <c:formatCode>General</c:formatCode>
                <c:ptCount val="37"/>
                <c:pt idx="0">
                  <c:v>6.1703333333333332E-2</c:v>
                </c:pt>
                <c:pt idx="1">
                  <c:v>2.5936666666666663E-2</c:v>
                </c:pt>
                <c:pt idx="2">
                  <c:v>4.0276666666666662E-2</c:v>
                </c:pt>
                <c:pt idx="3">
                  <c:v>3.4656666666666662E-2</c:v>
                </c:pt>
                <c:pt idx="4">
                  <c:v>3.155666666666667E-2</c:v>
                </c:pt>
                <c:pt idx="5">
                  <c:v>4.0170000000000004E-2</c:v>
                </c:pt>
                <c:pt idx="6">
                  <c:v>6.2963333333333329E-2</c:v>
                </c:pt>
                <c:pt idx="7">
                  <c:v>0.14021666666666668</c:v>
                </c:pt>
                <c:pt idx="8">
                  <c:v>0.18871333333333332</c:v>
                </c:pt>
                <c:pt idx="9">
                  <c:v>2.2723333333333335</c:v>
                </c:pt>
                <c:pt idx="10">
                  <c:v>15.404433333333335</c:v>
                </c:pt>
                <c:pt idx="11">
                  <c:v>63.259666666666668</c:v>
                </c:pt>
                <c:pt idx="12">
                  <c:v>173.51133333333334</c:v>
                </c:pt>
                <c:pt idx="13">
                  <c:v>355.59483333333333</c:v>
                </c:pt>
                <c:pt idx="14">
                  <c:v>619.80805000000009</c:v>
                </c:pt>
                <c:pt idx="15">
                  <c:v>938.50284666666664</c:v>
                </c:pt>
                <c:pt idx="16">
                  <c:v>1291.6836666666666</c:v>
                </c:pt>
                <c:pt idx="17">
                  <c:v>1656.2244666666666</c:v>
                </c:pt>
                <c:pt idx="18">
                  <c:v>2026.9605333333336</c:v>
                </c:pt>
                <c:pt idx="19">
                  <c:v>2365.5060333333336</c:v>
                </c:pt>
                <c:pt idx="20">
                  <c:v>2661.1407333333332</c:v>
                </c:pt>
                <c:pt idx="21">
                  <c:v>2908.4091666666668</c:v>
                </c:pt>
                <c:pt idx="22">
                  <c:v>3099.3561666666665</c:v>
                </c:pt>
                <c:pt idx="23">
                  <c:v>3251.297</c:v>
                </c:pt>
                <c:pt idx="24">
                  <c:v>3358.0214666666666</c:v>
                </c:pt>
                <c:pt idx="25">
                  <c:v>3414.3394666666668</c:v>
                </c:pt>
                <c:pt idx="26">
                  <c:v>3449.3215333333333</c:v>
                </c:pt>
                <c:pt idx="27">
                  <c:v>3453.2525999999998</c:v>
                </c:pt>
                <c:pt idx="28">
                  <c:v>3452.4381333333331</c:v>
                </c:pt>
                <c:pt idx="29">
                  <c:v>3438.9080333333332</c:v>
                </c:pt>
                <c:pt idx="30">
                  <c:v>3410.5324999999998</c:v>
                </c:pt>
                <c:pt idx="31">
                  <c:v>3386.6968666666667</c:v>
                </c:pt>
                <c:pt idx="32">
                  <c:v>3353.19096666666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35D-4341-A9A9-83854E52BD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9433088"/>
        <c:axId val="639425408"/>
      </c:scatterChart>
      <c:valAx>
        <c:axId val="6394330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Time (Sec)</a:t>
                </a:r>
              </a:p>
            </c:rich>
          </c:tx>
          <c:layout>
            <c:manualLayout>
              <c:xMode val="edge"/>
              <c:yMode val="edge"/>
              <c:x val="0.45872823708937754"/>
              <c:y val="0.895628487097162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IL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639425408"/>
        <c:crosses val="autoZero"/>
        <c:crossBetween val="midCat"/>
      </c:valAx>
      <c:valAx>
        <c:axId val="6394254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Storage shear Modulus, G’ (Pa)</a:t>
                </a:r>
              </a:p>
            </c:rich>
          </c:tx>
          <c:layout>
            <c:manualLayout>
              <c:xMode val="edge"/>
              <c:yMode val="edge"/>
              <c:x val="1.8477353216313778E-2"/>
              <c:y val="6.638452214624758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639433088"/>
        <c:crosses val="autoZero"/>
        <c:crossBetween val="midCat"/>
      </c:valAx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22773470903365722"/>
          <c:y val="0.1010568391054526"/>
          <c:w val="0.23978229682970637"/>
          <c:h val="0.158638008086827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IL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Untreated</c:v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nflamation area'!$D$6,'Inflamation area'!$J$6)</c:f>
                <c:numCache>
                  <c:formatCode>General</c:formatCode>
                  <c:ptCount val="2"/>
                  <c:pt idx="0">
                    <c:v>29713.73</c:v>
                  </c:pt>
                  <c:pt idx="1">
                    <c:v>2033.51</c:v>
                  </c:pt>
                </c:numCache>
              </c:numRef>
            </c:plus>
            <c:minus>
              <c:numRef>
                <c:f>('Inflamation area'!$D$6,'Inflamation area'!$J$6)</c:f>
                <c:numCache>
                  <c:formatCode>General</c:formatCode>
                  <c:ptCount val="2"/>
                  <c:pt idx="0">
                    <c:v>29713.73</c:v>
                  </c:pt>
                  <c:pt idx="1">
                    <c:v>2033.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nflamation area'!$D$3,'Inflamation are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Inflamation area'!$D$5,'Inflamation area'!$J$5)</c:f>
              <c:numCache>
                <c:formatCode>General</c:formatCode>
                <c:ptCount val="2"/>
                <c:pt idx="0">
                  <c:v>17362.77</c:v>
                </c:pt>
                <c:pt idx="1">
                  <c:v>1549.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12-5449-8880-FEF680BA1BDB}"/>
            </c:ext>
          </c:extLst>
        </c:ser>
        <c:ser>
          <c:idx val="1"/>
          <c:order val="1"/>
          <c:tx>
            <c:v>bCripto</c:v>
          </c:tx>
          <c:spPr>
            <a:solidFill>
              <a:srgbClr val="FAC09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nflamation area'!$E$6,'Inflamation area'!$K$6)</c:f>
                <c:numCache>
                  <c:formatCode>General</c:formatCode>
                  <c:ptCount val="2"/>
                  <c:pt idx="0">
                    <c:v>26100.79</c:v>
                  </c:pt>
                  <c:pt idx="1">
                    <c:v>6722.72</c:v>
                  </c:pt>
                </c:numCache>
              </c:numRef>
            </c:plus>
            <c:minus>
              <c:numRef>
                <c:f>('Inflamation area'!$E$6,'Inflamation area'!$K$6)</c:f>
                <c:numCache>
                  <c:formatCode>General</c:formatCode>
                  <c:ptCount val="2"/>
                  <c:pt idx="0">
                    <c:v>26100.79</c:v>
                  </c:pt>
                  <c:pt idx="1">
                    <c:v>6722.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nflamation area'!$D$3,'Inflamation are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Inflamation area'!$E$5,'Inflamation area'!$K$5)</c:f>
              <c:numCache>
                <c:formatCode>General</c:formatCode>
                <c:ptCount val="2"/>
                <c:pt idx="0">
                  <c:v>33408.51</c:v>
                </c:pt>
                <c:pt idx="1">
                  <c:v>3361.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D12-5449-8880-FEF680BA1BDB}"/>
            </c:ext>
          </c:extLst>
        </c:ser>
        <c:ser>
          <c:idx val="2"/>
          <c:order val="2"/>
          <c:tx>
            <c:v>Empty PF</c:v>
          </c:tx>
          <c:spPr>
            <a:solidFill>
              <a:srgbClr val="31859C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nflamation area'!$F$6,'Inflamation area'!$L$6)</c:f>
                <c:numCache>
                  <c:formatCode>General</c:formatCode>
                  <c:ptCount val="2"/>
                  <c:pt idx="0">
                    <c:v>635193.57999999996</c:v>
                  </c:pt>
                  <c:pt idx="1">
                    <c:v>339360.65</c:v>
                  </c:pt>
                </c:numCache>
              </c:numRef>
            </c:plus>
            <c:minus>
              <c:numRef>
                <c:f>('Inflamation area'!$F$6,'Inflamation area'!$L$6)</c:f>
                <c:numCache>
                  <c:formatCode>General</c:formatCode>
                  <c:ptCount val="2"/>
                  <c:pt idx="0">
                    <c:v>635193.57999999996</c:v>
                  </c:pt>
                  <c:pt idx="1">
                    <c:v>339360.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nflamation area'!$D$3,'Inflamation are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Inflamation area'!$F$5,'Inflamation area'!$L$5)</c:f>
              <c:numCache>
                <c:formatCode>0</c:formatCode>
                <c:ptCount val="2"/>
                <c:pt idx="0" formatCode="General">
                  <c:v>903852.8</c:v>
                </c:pt>
                <c:pt idx="1">
                  <c:v>355432.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D12-5449-8880-FEF680BA1BDB}"/>
            </c:ext>
          </c:extLst>
        </c:ser>
        <c:ser>
          <c:idx val="3"/>
          <c:order val="3"/>
          <c:tx>
            <c:v>PF-Cripto</c:v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Inflamation area'!$G$6,'Inflamation area'!$M$6)</c:f>
                <c:numCache>
                  <c:formatCode>General</c:formatCode>
                  <c:ptCount val="2"/>
                  <c:pt idx="0">
                    <c:v>152224.91</c:v>
                  </c:pt>
                  <c:pt idx="1">
                    <c:v>110152.55424397151</c:v>
                  </c:pt>
                </c:numCache>
              </c:numRef>
            </c:plus>
            <c:minus>
              <c:numRef>
                <c:f>('Inflamation area'!$G$6,'Inflamation area'!$M$6)</c:f>
                <c:numCache>
                  <c:formatCode>General</c:formatCode>
                  <c:ptCount val="2"/>
                  <c:pt idx="0">
                    <c:v>152224.91</c:v>
                  </c:pt>
                  <c:pt idx="1">
                    <c:v>110152.554243971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Inflamation area'!$D$3,'Inflamation are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Inflamation area'!$G$5,'Inflamation area'!$M$5)</c:f>
              <c:numCache>
                <c:formatCode>0</c:formatCode>
                <c:ptCount val="2"/>
                <c:pt idx="0" formatCode="General">
                  <c:v>164354.57999999999</c:v>
                </c:pt>
                <c:pt idx="1">
                  <c:v>132596.87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D12-5449-8880-FEF680BA1B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23212559"/>
        <c:axId val="1323210063"/>
      </c:barChart>
      <c:catAx>
        <c:axId val="1323212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1323210063"/>
        <c:crosses val="autoZero"/>
        <c:auto val="1"/>
        <c:lblAlgn val="ctr"/>
        <c:lblOffset val="100"/>
        <c:noMultiLvlLbl val="0"/>
      </c:catAx>
      <c:valAx>
        <c:axId val="1323210063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Averaged area of inflammation [</a:t>
                </a:r>
                <a:r>
                  <a:rPr lang="el-GR" b="1">
                    <a:solidFill>
                      <a:sysClr val="windowText" lastClr="000000"/>
                    </a:solidFill>
                  </a:rPr>
                  <a:t>μ</a:t>
                </a:r>
                <a:r>
                  <a:rPr lang="en-US" b="1">
                    <a:solidFill>
                      <a:sysClr val="windowText" lastClr="000000"/>
                    </a:solidFill>
                  </a:rPr>
                  <a:t>m</a:t>
                </a:r>
                <a:r>
                  <a:rPr lang="en-US" b="1" baseline="30000">
                    <a:solidFill>
                      <a:sysClr val="windowText" lastClr="000000"/>
                    </a:solidFill>
                  </a:rPr>
                  <a:t>2</a:t>
                </a:r>
                <a:r>
                  <a:rPr lang="en-US" b="1">
                    <a:solidFill>
                      <a:sysClr val="windowText" lastClr="000000"/>
                    </a:solidFill>
                  </a:rPr>
                  <a:t>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1323212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Untreated</c:v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%EDEMA'!$D$6,'%EDEMA'!$J$6)</c:f>
                <c:numCache>
                  <c:formatCode>General</c:formatCode>
                  <c:ptCount val="2"/>
                  <c:pt idx="0">
                    <c:v>2.6</c:v>
                  </c:pt>
                  <c:pt idx="1">
                    <c:v>6.11</c:v>
                  </c:pt>
                </c:numCache>
              </c:numRef>
            </c:plus>
            <c:minus>
              <c:numRef>
                <c:f>('%EDEMA'!$D$6,'%EDEMA'!$J$6)</c:f>
                <c:numCache>
                  <c:formatCode>General</c:formatCode>
                  <c:ptCount val="2"/>
                  <c:pt idx="0">
                    <c:v>2.6</c:v>
                  </c:pt>
                  <c:pt idx="1">
                    <c:v>6.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%EDEMA'!$D$3,'%EDEM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%EDEMA'!$D$5,'%EDEMA'!$J$5)</c:f>
              <c:numCache>
                <c:formatCode>General</c:formatCode>
                <c:ptCount val="2"/>
                <c:pt idx="0">
                  <c:v>10.85</c:v>
                </c:pt>
                <c:pt idx="1">
                  <c:v>8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A2-474D-B15D-C9550AB2799F}"/>
            </c:ext>
          </c:extLst>
        </c:ser>
        <c:ser>
          <c:idx val="1"/>
          <c:order val="1"/>
          <c:tx>
            <c:v>bCripto</c:v>
          </c:tx>
          <c:spPr>
            <a:solidFill>
              <a:srgbClr val="FAC09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%EDEMA'!$E$6,'%EDEMA'!$K$6)</c:f>
                <c:numCache>
                  <c:formatCode>General</c:formatCode>
                  <c:ptCount val="2"/>
                  <c:pt idx="0">
                    <c:v>2.38</c:v>
                  </c:pt>
                  <c:pt idx="1">
                    <c:v>3.73</c:v>
                  </c:pt>
                </c:numCache>
              </c:numRef>
            </c:plus>
            <c:minus>
              <c:numRef>
                <c:f>('%EDEMA'!$E$6,'%EDEMA'!$K$6)</c:f>
                <c:numCache>
                  <c:formatCode>General</c:formatCode>
                  <c:ptCount val="2"/>
                  <c:pt idx="0">
                    <c:v>2.38</c:v>
                  </c:pt>
                  <c:pt idx="1">
                    <c:v>3.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%EDEMA'!$D$3,'%EDEM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%EDEMA'!$E$5,'%EDEMA'!$K$5)</c:f>
              <c:numCache>
                <c:formatCode>General</c:formatCode>
                <c:ptCount val="2"/>
                <c:pt idx="0">
                  <c:v>8.91</c:v>
                </c:pt>
                <c:pt idx="1">
                  <c:v>6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EA2-474D-B15D-C9550AB2799F}"/>
            </c:ext>
          </c:extLst>
        </c:ser>
        <c:ser>
          <c:idx val="2"/>
          <c:order val="2"/>
          <c:tx>
            <c:v>Empty PF</c:v>
          </c:tx>
          <c:spPr>
            <a:solidFill>
              <a:srgbClr val="31859C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%EDEMA'!$F$6,'%EDEMA'!$L$6)</c:f>
                <c:numCache>
                  <c:formatCode>General</c:formatCode>
                  <c:ptCount val="2"/>
                  <c:pt idx="0">
                    <c:v>1.0900000000000001</c:v>
                  </c:pt>
                  <c:pt idx="1">
                    <c:v>3.9</c:v>
                  </c:pt>
                </c:numCache>
              </c:numRef>
            </c:plus>
            <c:minus>
              <c:numRef>
                <c:f>('%EDEMA'!$F$6,'%EDEMA'!$L$6)</c:f>
                <c:numCache>
                  <c:formatCode>General</c:formatCode>
                  <c:ptCount val="2"/>
                  <c:pt idx="0">
                    <c:v>1.0900000000000001</c:v>
                  </c:pt>
                  <c:pt idx="1">
                    <c:v>3.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%EDEMA'!$D$3,'%EDEM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%EDEMA'!$F$5,'%EDEMA'!$L$5)</c:f>
              <c:numCache>
                <c:formatCode>0</c:formatCode>
                <c:ptCount val="2"/>
                <c:pt idx="0" formatCode="General">
                  <c:v>14.46</c:v>
                </c:pt>
                <c:pt idx="1">
                  <c:v>7.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EA2-474D-B15D-C9550AB2799F}"/>
            </c:ext>
          </c:extLst>
        </c:ser>
        <c:ser>
          <c:idx val="3"/>
          <c:order val="3"/>
          <c:tx>
            <c:v>PF-Cripto</c:v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%EDEMA'!$G$6,'%EDEMA'!$M$6)</c:f>
                <c:numCache>
                  <c:formatCode>General</c:formatCode>
                  <c:ptCount val="2"/>
                  <c:pt idx="0">
                    <c:v>0.91</c:v>
                  </c:pt>
                  <c:pt idx="1">
                    <c:v>5.36</c:v>
                  </c:pt>
                </c:numCache>
              </c:numRef>
            </c:plus>
            <c:minus>
              <c:numRef>
                <c:f>('%EDEMA'!$G$6,'%EDEMA'!$M$6)</c:f>
                <c:numCache>
                  <c:formatCode>General</c:formatCode>
                  <c:ptCount val="2"/>
                  <c:pt idx="0">
                    <c:v>0.91</c:v>
                  </c:pt>
                  <c:pt idx="1">
                    <c:v>5.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%EDEMA'!$D$3,'%EDEMA'!$J$3)</c:f>
              <c:strCache>
                <c:ptCount val="2"/>
                <c:pt idx="0">
                  <c:v>7 Days</c:v>
                </c:pt>
                <c:pt idx="1">
                  <c:v>23 Days</c:v>
                </c:pt>
              </c:strCache>
            </c:strRef>
          </c:cat>
          <c:val>
            <c:numRef>
              <c:f>('%EDEMA'!$G$5,'%EDEMA'!$M$5)</c:f>
              <c:numCache>
                <c:formatCode>0</c:formatCode>
                <c:ptCount val="2"/>
                <c:pt idx="0" formatCode="General">
                  <c:v>12.17</c:v>
                </c:pt>
                <c:pt idx="1">
                  <c:v>8.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EA2-474D-B15D-C9550AB279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23212559"/>
        <c:axId val="1323210063"/>
      </c:barChart>
      <c:catAx>
        <c:axId val="1323212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1323210063"/>
        <c:crosses val="autoZero"/>
        <c:auto val="1"/>
        <c:lblAlgn val="ctr"/>
        <c:lblOffset val="100"/>
        <c:noMultiLvlLbl val="0"/>
      </c:catAx>
      <c:valAx>
        <c:axId val="1323210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Averaged % of edem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1323212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4975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9375" y="0"/>
            <a:ext cx="2974975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F618F7-337A-D740-BC11-B5B45E0A7C84}" type="datetimeFigureOut">
              <a:rPr lang="en-IL" smtClean="0"/>
              <a:t>15/01/2024</a:t>
            </a:fld>
            <a:endParaRPr lang="en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9363"/>
            <a:ext cx="2387600" cy="3375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7388" y="4811713"/>
            <a:ext cx="5492750" cy="39370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96425"/>
            <a:ext cx="2974975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9375" y="9496425"/>
            <a:ext cx="2974975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B84FC4-2006-9642-9C34-0BEACD6865F4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277667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17330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88516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21387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89902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84646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28820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26507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1709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70483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81899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27518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507FA-1C4F-4953-8DA2-118A37E29B61}" type="datetimeFigureOut">
              <a:rPr lang="he-IL" smtClean="0"/>
              <a:t>ה'.שבט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FE60C-3F99-4F9D-9D3A-E5F1982475B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14223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1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r" defTabSz="755934" rtl="1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r" defTabSz="755934" rtl="1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r" defTabSz="755934" rtl="1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5" Type="http://schemas.openxmlformats.org/officeDocument/2006/relationships/image" Target="../media/image2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Relationship Id="rId1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9C19FF43-E709-E79B-04EE-E8F5ECBE8B4A}"/>
              </a:ext>
            </a:extLst>
          </p:cNvPr>
          <p:cNvSpPr txBox="1"/>
          <p:nvPr/>
        </p:nvSpPr>
        <p:spPr>
          <a:xfrm>
            <a:off x="270728" y="177863"/>
            <a:ext cx="3571169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1</a:t>
            </a:r>
            <a:endParaRPr lang="he-IL" sz="2115" b="1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3728343-67EA-B49D-859B-913E5E992CE7}"/>
              </a:ext>
            </a:extLst>
          </p:cNvPr>
          <p:cNvGrpSpPr/>
          <p:nvPr/>
        </p:nvGrpSpPr>
        <p:grpSpPr>
          <a:xfrm>
            <a:off x="184829" y="2338422"/>
            <a:ext cx="7101361" cy="4822901"/>
            <a:chOff x="184829" y="572386"/>
            <a:chExt cx="7101361" cy="4822901"/>
          </a:xfrm>
        </p:grpSpPr>
        <p:pic>
          <p:nvPicPr>
            <p:cNvPr id="47" name="Picture 46" descr="BioRender | Life Science Icons">
              <a:extLst>
                <a:ext uri="{FF2B5EF4-FFF2-40B4-BE49-F238E27FC236}">
                  <a16:creationId xmlns:a16="http://schemas.microsoft.com/office/drawing/2014/main" id="{02454907-08B4-31C0-7085-D0160AFF90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685"/>
            <a:stretch/>
          </p:blipFill>
          <p:spPr bwMode="auto">
            <a:xfrm>
              <a:off x="636932" y="593837"/>
              <a:ext cx="2170041" cy="257867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64" name="Picture 63" descr="BioRender | Life Science Icons">
              <a:extLst>
                <a:ext uri="{FF2B5EF4-FFF2-40B4-BE49-F238E27FC236}">
                  <a16:creationId xmlns:a16="http://schemas.microsoft.com/office/drawing/2014/main" id="{75C6CAF7-52A4-1C29-7032-4AD9A41A1D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685"/>
            <a:stretch/>
          </p:blipFill>
          <p:spPr bwMode="auto">
            <a:xfrm>
              <a:off x="4328843" y="572386"/>
              <a:ext cx="2170041" cy="257867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E7814E57-6884-1796-CBDD-112079A80EB8}"/>
                </a:ext>
              </a:extLst>
            </p:cNvPr>
            <p:cNvGrpSpPr/>
            <p:nvPr/>
          </p:nvGrpSpPr>
          <p:grpSpPr>
            <a:xfrm>
              <a:off x="184829" y="898459"/>
              <a:ext cx="7101361" cy="4496828"/>
              <a:chOff x="184829" y="898459"/>
              <a:chExt cx="7101361" cy="4496828"/>
            </a:xfrm>
          </p:grpSpPr>
          <p:sp>
            <p:nvSpPr>
              <p:cNvPr id="48" name="Text Box 2">
                <a:extLst>
                  <a:ext uri="{FF2B5EF4-FFF2-40B4-BE49-F238E27FC236}">
                    <a16:creationId xmlns:a16="http://schemas.microsoft.com/office/drawing/2014/main" id="{79ECDF12-70E3-805F-9534-8875E9C8624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58707" y="1552840"/>
                <a:ext cx="1303422" cy="4362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X 5 Mice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 Box 2">
                <a:extLst>
                  <a:ext uri="{FF2B5EF4-FFF2-40B4-BE49-F238E27FC236}">
                    <a16:creationId xmlns:a16="http://schemas.microsoft.com/office/drawing/2014/main" id="{DD35DDB3-0159-56B1-B7BB-4F9CD797EB2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447820" y="1667236"/>
                <a:ext cx="651393" cy="2304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Ventral</a:t>
                </a:r>
                <a:endParaRPr lang="en-IL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 Box 2">
                <a:extLst>
                  <a:ext uri="{FF2B5EF4-FFF2-40B4-BE49-F238E27FC236}">
                    <a16:creationId xmlns:a16="http://schemas.microsoft.com/office/drawing/2014/main" id="{81B27EBE-9E7C-175D-02FE-ED051A83CA9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23557" y="2628976"/>
                <a:ext cx="1097280" cy="4465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TX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0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מחבר חץ ישר 200">
                <a:extLst>
                  <a:ext uri="{FF2B5EF4-FFF2-40B4-BE49-F238E27FC236}">
                    <a16:creationId xmlns:a16="http://schemas.microsoft.com/office/drawing/2014/main" id="{4BD82D1F-8837-4BBA-BF02-5B61D2CE8C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23558" y="2207827"/>
                <a:ext cx="358104" cy="45717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 Box 2">
                <a:extLst>
                  <a:ext uri="{FF2B5EF4-FFF2-40B4-BE49-F238E27FC236}">
                    <a16:creationId xmlns:a16="http://schemas.microsoft.com/office/drawing/2014/main" id="{4AB4303C-B018-B79E-B715-A0A8C810F1F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77686" y="2001183"/>
                <a:ext cx="255700" cy="2173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 Box 2">
                <a:extLst>
                  <a:ext uri="{FF2B5EF4-FFF2-40B4-BE49-F238E27FC236}">
                    <a16:creationId xmlns:a16="http://schemas.microsoft.com/office/drawing/2014/main" id="{CD71BE5E-DA39-4E4F-7E33-CFA3F48EC6E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40449" y="2001151"/>
                <a:ext cx="210659" cy="2782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מחבר חץ ישר 200">
                <a:extLst>
                  <a:ext uri="{FF2B5EF4-FFF2-40B4-BE49-F238E27FC236}">
                    <a16:creationId xmlns:a16="http://schemas.microsoft.com/office/drawing/2014/main" id="{DCC1AE86-487C-634B-FE5A-BA1067B5A3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78776" y="2207912"/>
                <a:ext cx="341845" cy="45719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 Box 2">
                <a:extLst>
                  <a:ext uri="{FF2B5EF4-FFF2-40B4-BE49-F238E27FC236}">
                    <a16:creationId xmlns:a16="http://schemas.microsoft.com/office/drawing/2014/main" id="{52E11C4F-20ED-817D-3D9B-055205E72B6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37045" y="3455785"/>
                <a:ext cx="1197607" cy="6276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d-PF + </a:t>
                </a:r>
                <a:r>
                  <a:rPr lang="en-US" sz="1100" b="1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ipto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(25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 Box 2">
                <a:extLst>
                  <a:ext uri="{FF2B5EF4-FFF2-40B4-BE49-F238E27FC236}">
                    <a16:creationId xmlns:a16="http://schemas.microsoft.com/office/drawing/2014/main" id="{245AB86C-F8F6-3E45-3319-D1DA329B12D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9075" y="2629251"/>
                <a:ext cx="1226352" cy="6276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d-PF + </a:t>
                </a:r>
                <a:r>
                  <a:rPr lang="en-US" sz="1100" b="1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ipto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(25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 Box 2">
                <a:extLst>
                  <a:ext uri="{FF2B5EF4-FFF2-40B4-BE49-F238E27FC236}">
                    <a16:creationId xmlns:a16="http://schemas.microsoft.com/office/drawing/2014/main" id="{1446B096-04C2-0101-6A81-EADE5446D95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7933" y="2255653"/>
                <a:ext cx="841707" cy="2782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lang="en-IL" sz="110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 Box 2">
                <a:extLst>
                  <a:ext uri="{FF2B5EF4-FFF2-40B4-BE49-F238E27FC236}">
                    <a16:creationId xmlns:a16="http://schemas.microsoft.com/office/drawing/2014/main" id="{7A15309D-65D2-AAA3-AECE-1F0961C8FBE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43123" y="2255653"/>
                <a:ext cx="841707" cy="2782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lang="en-IL" sz="110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 Box 2">
                <a:extLst>
                  <a:ext uri="{FF2B5EF4-FFF2-40B4-BE49-F238E27FC236}">
                    <a16:creationId xmlns:a16="http://schemas.microsoft.com/office/drawing/2014/main" id="{6A9AF87C-475F-DC16-75DD-3237F727671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38293" y="3108452"/>
                <a:ext cx="930303" cy="456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ctr" anchorCtr="0">
                <a:noAutofit/>
              </a:bodyPr>
              <a:lstStyle/>
              <a:p>
                <a:r>
                  <a:rPr lang="en-US" sz="900" dirty="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30-minute</a:t>
                </a:r>
                <a:endParaRPr lang="en-IL" sz="1100" dirty="0">
                  <a:solidFill>
                    <a:schemeClr val="accent6">
                      <a:lumMod val="75000"/>
                    </a:schemeClr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r>
                  <a:rPr lang="en-US" sz="900" dirty="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aiting period</a:t>
                </a:r>
                <a:endParaRPr lang="en-IL" sz="1100" dirty="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 Box 2">
                <a:extLst>
                  <a:ext uri="{FF2B5EF4-FFF2-40B4-BE49-F238E27FC236}">
                    <a16:creationId xmlns:a16="http://schemas.microsoft.com/office/drawing/2014/main" id="{F9394451-6A31-DCD9-15BE-638F19DC946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50618" y="1552840"/>
                <a:ext cx="1303422" cy="4362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X 5 Mice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 Box 2">
                <a:extLst>
                  <a:ext uri="{FF2B5EF4-FFF2-40B4-BE49-F238E27FC236}">
                    <a16:creationId xmlns:a16="http://schemas.microsoft.com/office/drawing/2014/main" id="{DECE93F5-4BAA-45E4-B5BF-B8C1255EB42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39731" y="1656204"/>
                <a:ext cx="651393" cy="2304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Ventral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 Box 2">
                <a:extLst>
                  <a:ext uri="{FF2B5EF4-FFF2-40B4-BE49-F238E27FC236}">
                    <a16:creationId xmlns:a16="http://schemas.microsoft.com/office/drawing/2014/main" id="{10521051-0A87-733F-6AA9-2D985E9C29A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815468" y="2617944"/>
                <a:ext cx="1097280" cy="4465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TX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0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7" name="מחבר חץ ישר 200">
                <a:extLst>
                  <a:ext uri="{FF2B5EF4-FFF2-40B4-BE49-F238E27FC236}">
                    <a16:creationId xmlns:a16="http://schemas.microsoft.com/office/drawing/2014/main" id="{74A0F8C7-D9E3-75A3-191F-836679FED7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15469" y="2196795"/>
                <a:ext cx="358104" cy="45717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 Box 2">
                <a:extLst>
                  <a:ext uri="{FF2B5EF4-FFF2-40B4-BE49-F238E27FC236}">
                    <a16:creationId xmlns:a16="http://schemas.microsoft.com/office/drawing/2014/main" id="{57ED71A4-07F0-863A-CB21-B2986FDE13B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984634" y="1990151"/>
                <a:ext cx="359279" cy="278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 Box 2">
                <a:extLst>
                  <a:ext uri="{FF2B5EF4-FFF2-40B4-BE49-F238E27FC236}">
                    <a16:creationId xmlns:a16="http://schemas.microsoft.com/office/drawing/2014/main" id="{F9E22761-851E-7667-4CF3-FB4668AD21E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632360" y="1990119"/>
                <a:ext cx="241043" cy="2782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0" name="מחבר חץ ישר 200">
                <a:extLst>
                  <a:ext uri="{FF2B5EF4-FFF2-40B4-BE49-F238E27FC236}">
                    <a16:creationId xmlns:a16="http://schemas.microsoft.com/office/drawing/2014/main" id="{900CB4C8-F2C7-5DCE-5501-30743D9F98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70687" y="2196880"/>
                <a:ext cx="341845" cy="45719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>
                <a:extLst>
                  <a:ext uri="{FF2B5EF4-FFF2-40B4-BE49-F238E27FC236}">
                    <a16:creationId xmlns:a16="http://schemas.microsoft.com/office/drawing/2014/main" id="{60FEB0A2-74A0-EF4E-84BF-31FFEAF143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83693" y="3161475"/>
                <a:ext cx="0" cy="31903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 Box 2">
                <a:extLst>
                  <a:ext uri="{FF2B5EF4-FFF2-40B4-BE49-F238E27FC236}">
                    <a16:creationId xmlns:a16="http://schemas.microsoft.com/office/drawing/2014/main" id="{A36F2F8A-B089-531B-1855-08DAFCE6E67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709255" y="3444753"/>
                <a:ext cx="1197632" cy="6276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mpty Gd-PF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(25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 Box 2">
                <a:extLst>
                  <a:ext uri="{FF2B5EF4-FFF2-40B4-BE49-F238E27FC236}">
                    <a16:creationId xmlns:a16="http://schemas.microsoft.com/office/drawing/2014/main" id="{A0C03F63-9D6B-F65C-2C9D-30921E8CE65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23773" y="2618219"/>
                <a:ext cx="1187471" cy="6276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mpty Gd-PF 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(25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 Box 2">
                <a:extLst>
                  <a:ext uri="{FF2B5EF4-FFF2-40B4-BE49-F238E27FC236}">
                    <a16:creationId xmlns:a16="http://schemas.microsoft.com/office/drawing/2014/main" id="{6D38A87C-49A7-8703-62D6-F1202884D07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69844" y="2244621"/>
                <a:ext cx="841707" cy="2782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lang="en-IL" sz="110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 Box 2">
                <a:extLst>
                  <a:ext uri="{FF2B5EF4-FFF2-40B4-BE49-F238E27FC236}">
                    <a16:creationId xmlns:a16="http://schemas.microsoft.com/office/drawing/2014/main" id="{B40BE487-9FAC-3ECD-82A8-510F33B01A8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35034" y="2244621"/>
                <a:ext cx="841707" cy="2782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lang="en-IL" sz="110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 Box 2">
                <a:extLst>
                  <a:ext uri="{FF2B5EF4-FFF2-40B4-BE49-F238E27FC236}">
                    <a16:creationId xmlns:a16="http://schemas.microsoft.com/office/drawing/2014/main" id="{1FF412A2-A784-0758-6839-3F3E999CD5D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355887" y="3075922"/>
                <a:ext cx="930303" cy="456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ctr" anchorCtr="0">
                <a:noAutofit/>
              </a:bodyPr>
              <a:lstStyle>
                <a:defPPr>
                  <a:defRPr lang="en-US"/>
                </a:defPPr>
                <a:lvl1pPr>
                  <a:defRPr sz="900">
                    <a:solidFill>
                      <a:srgbClr val="FF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dirty="0">
                    <a:solidFill>
                      <a:schemeClr val="accent6">
                        <a:lumMod val="75000"/>
                      </a:schemeClr>
                    </a:solidFill>
                  </a:rPr>
                  <a:t>30-minute</a:t>
                </a:r>
                <a:endParaRPr lang="en-IL" dirty="0">
                  <a:solidFill>
                    <a:schemeClr val="accent6">
                      <a:lumMod val="75000"/>
                    </a:schemeClr>
                  </a:solidFill>
                </a:endParaRPr>
              </a:p>
              <a:p>
                <a:r>
                  <a:rPr lang="en-US" dirty="0">
                    <a:solidFill>
                      <a:schemeClr val="accent6">
                        <a:lumMod val="75000"/>
                      </a:schemeClr>
                    </a:solidFill>
                  </a:rPr>
                  <a:t>waiting period</a:t>
                </a:r>
                <a:endParaRPr lang="en-IL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1089" name="Rectangle 1088">
                <a:extLst>
                  <a:ext uri="{FF2B5EF4-FFF2-40B4-BE49-F238E27FC236}">
                    <a16:creationId xmlns:a16="http://schemas.microsoft.com/office/drawing/2014/main" id="{036999D1-806B-4145-6CEA-8104C5072D0B}"/>
                  </a:ext>
                </a:extLst>
              </p:cNvPr>
              <p:cNvSpPr/>
              <p:nvPr/>
            </p:nvSpPr>
            <p:spPr>
              <a:xfrm>
                <a:off x="330200" y="898459"/>
                <a:ext cx="6910992" cy="4418070"/>
              </a:xfrm>
              <a:prstGeom prst="rect">
                <a:avLst/>
              </a:prstGeom>
              <a:noFill/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L"/>
              </a:p>
            </p:txBody>
          </p:sp>
          <p:cxnSp>
            <p:nvCxnSpPr>
              <p:cNvPr id="1096" name="Straight Connector 1095">
                <a:extLst>
                  <a:ext uri="{FF2B5EF4-FFF2-40B4-BE49-F238E27FC236}">
                    <a16:creationId xmlns:a16="http://schemas.microsoft.com/office/drawing/2014/main" id="{352E87E0-5840-73EA-9111-8752F1E0F9B1}"/>
                  </a:ext>
                </a:extLst>
              </p:cNvPr>
              <p:cNvCxnSpPr/>
              <p:nvPr/>
            </p:nvCxnSpPr>
            <p:spPr>
              <a:xfrm>
                <a:off x="586322" y="4690773"/>
                <a:ext cx="6326426" cy="0"/>
              </a:xfrm>
              <a:prstGeom prst="line">
                <a:avLst/>
              </a:prstGeom>
              <a:ln w="12700">
                <a:solidFill>
                  <a:schemeClr val="accent5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8" name="Text Box 2">
                <a:extLst>
                  <a:ext uri="{FF2B5EF4-FFF2-40B4-BE49-F238E27FC236}">
                    <a16:creationId xmlns:a16="http://schemas.microsoft.com/office/drawing/2014/main" id="{F1135771-5A9E-B3FF-F1D5-50A35FEFF3D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76023" y="4938651"/>
                <a:ext cx="1985145" cy="456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ctr" anchorCtr="0">
                <a:noAutofit/>
              </a:bodyPr>
              <a:lstStyle/>
              <a:p>
                <a:pPr algn="ctr"/>
                <a:r>
                  <a:rPr lang="en-IL" sz="1400" dirty="0">
                    <a:solidFill>
                      <a:srgbClr val="FF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Sacrafice at day 28</a:t>
                </a:r>
              </a:p>
            </p:txBody>
          </p:sp>
          <p:cxnSp>
            <p:nvCxnSpPr>
              <p:cNvPr id="1099" name="Straight Arrow Connector 1098">
                <a:extLst>
                  <a:ext uri="{FF2B5EF4-FFF2-40B4-BE49-F238E27FC236}">
                    <a16:creationId xmlns:a16="http://schemas.microsoft.com/office/drawing/2014/main" id="{48AEEF2B-5AE6-3314-62B4-3D880AC9B1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87885" y="3172507"/>
                <a:ext cx="0" cy="31903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1" name="TextBox 1110">
                <a:extLst>
                  <a:ext uri="{FF2B5EF4-FFF2-40B4-BE49-F238E27FC236}">
                    <a16:creationId xmlns:a16="http://schemas.microsoft.com/office/drawing/2014/main" id="{AB09069E-DBD7-C922-0F67-D7A8A8C7C90A}"/>
                  </a:ext>
                </a:extLst>
              </p:cNvPr>
              <p:cNvSpPr txBox="1"/>
              <p:nvPr/>
            </p:nvSpPr>
            <p:spPr>
              <a:xfrm>
                <a:off x="184829" y="4087740"/>
                <a:ext cx="1925942" cy="543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roup 1: </a:t>
                </a:r>
              </a:p>
              <a:p>
                <a:pPr algn="ctr">
                  <a:lnSpc>
                    <a:spcPct val="107000"/>
                  </a:lnSpc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d-PF-</a:t>
                </a:r>
                <a:r>
                  <a:rPr lang="en-US" sz="1400" b="1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ipto</a:t>
                </a: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w/o CTX</a:t>
                </a:r>
                <a:endParaRPr lang="en-IL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3" name="TextBox 1112">
                <a:extLst>
                  <a:ext uri="{FF2B5EF4-FFF2-40B4-BE49-F238E27FC236}">
                    <a16:creationId xmlns:a16="http://schemas.microsoft.com/office/drawing/2014/main" id="{383772A9-66ED-F293-7AF5-F177E302B1D9}"/>
                  </a:ext>
                </a:extLst>
              </p:cNvPr>
              <p:cNvSpPr txBox="1"/>
              <p:nvPr/>
            </p:nvSpPr>
            <p:spPr>
              <a:xfrm>
                <a:off x="1977772" y="4073942"/>
                <a:ext cx="1717151" cy="543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ctr">
                  <a:lnSpc>
                    <a:spcPct val="107000"/>
                  </a:lnSpc>
                  <a:defRPr sz="1200" b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sz="1400" dirty="0"/>
                  <a:t>Group 2: </a:t>
                </a:r>
              </a:p>
              <a:p>
                <a:r>
                  <a:rPr lang="en-US" sz="1400" dirty="0"/>
                  <a:t>Gd-PF-</a:t>
                </a:r>
                <a:r>
                  <a:rPr lang="en-US" sz="1400" dirty="0" err="1"/>
                  <a:t>Cripto</a:t>
                </a:r>
                <a:r>
                  <a:rPr lang="en-US" sz="1400" dirty="0"/>
                  <a:t> w/CTX</a:t>
                </a:r>
                <a:endParaRPr lang="en-IL" sz="1400" dirty="0"/>
              </a:p>
            </p:txBody>
          </p:sp>
          <p:sp>
            <p:nvSpPr>
              <p:cNvPr id="1114" name="TextBox 1113">
                <a:extLst>
                  <a:ext uri="{FF2B5EF4-FFF2-40B4-BE49-F238E27FC236}">
                    <a16:creationId xmlns:a16="http://schemas.microsoft.com/office/drawing/2014/main" id="{D676522C-0857-1BD1-A7BC-844043018858}"/>
                  </a:ext>
                </a:extLst>
              </p:cNvPr>
              <p:cNvSpPr txBox="1"/>
              <p:nvPr/>
            </p:nvSpPr>
            <p:spPr>
              <a:xfrm>
                <a:off x="4214445" y="4090792"/>
                <a:ext cx="1407669" cy="543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roup 3: </a:t>
                </a:r>
              </a:p>
              <a:p>
                <a:pPr algn="ctr">
                  <a:lnSpc>
                    <a:spcPct val="107000"/>
                  </a:lnSpc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d-PF w/o CTX</a:t>
                </a:r>
                <a:endParaRPr lang="en-IL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5" name="TextBox 1114">
                <a:extLst>
                  <a:ext uri="{FF2B5EF4-FFF2-40B4-BE49-F238E27FC236}">
                    <a16:creationId xmlns:a16="http://schemas.microsoft.com/office/drawing/2014/main" id="{6DF6ECFD-8B7C-F0F2-36FF-4B07E2111BCE}"/>
                  </a:ext>
                </a:extLst>
              </p:cNvPr>
              <p:cNvSpPr txBox="1"/>
              <p:nvPr/>
            </p:nvSpPr>
            <p:spPr>
              <a:xfrm>
                <a:off x="5789735" y="4085540"/>
                <a:ext cx="1407668" cy="5431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algn="ctr">
                  <a:lnSpc>
                    <a:spcPct val="107000"/>
                  </a:lnSpc>
                  <a:defRPr sz="1200" b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sz="1400" dirty="0"/>
                  <a:t>Group 4: </a:t>
                </a:r>
              </a:p>
              <a:p>
                <a:r>
                  <a:rPr lang="en-US" sz="1400" dirty="0"/>
                  <a:t>Gd-PF w/CTX</a:t>
                </a:r>
                <a:endParaRPr lang="en-IL" sz="1400" dirty="0"/>
              </a:p>
            </p:txBody>
          </p:sp>
          <p:cxnSp>
            <p:nvCxnSpPr>
              <p:cNvPr id="1118" name="Straight Connector 1117">
                <a:extLst>
                  <a:ext uri="{FF2B5EF4-FFF2-40B4-BE49-F238E27FC236}">
                    <a16:creationId xmlns:a16="http://schemas.microsoft.com/office/drawing/2014/main" id="{06321839-9BE7-3212-AB7A-4DB1DD3A3E79}"/>
                  </a:ext>
                </a:extLst>
              </p:cNvPr>
              <p:cNvCxnSpPr/>
              <p:nvPr/>
            </p:nvCxnSpPr>
            <p:spPr>
              <a:xfrm>
                <a:off x="597962" y="5011124"/>
                <a:ext cx="6326426" cy="0"/>
              </a:xfrm>
              <a:prstGeom prst="line">
                <a:avLst/>
              </a:prstGeom>
              <a:ln w="12700">
                <a:solidFill>
                  <a:schemeClr val="accent5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9" name="Text Box 2">
                <a:extLst>
                  <a:ext uri="{FF2B5EF4-FFF2-40B4-BE49-F238E27FC236}">
                    <a16:creationId xmlns:a16="http://schemas.microsoft.com/office/drawing/2014/main" id="{0B83D9DF-7FB3-9682-D3BF-9DF110E15C3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19673" y="4623096"/>
                <a:ext cx="5442042" cy="456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ctr" anchorCtr="0">
                <a:noAutofit/>
              </a:bodyPr>
              <a:lstStyle/>
              <a:p>
                <a:pPr algn="ctr"/>
                <a:r>
                  <a:rPr lang="en-IL" sz="1400" b="1" dirty="0"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RI assessments: day 0, day 1, day 4, day 7, day 14, day 21, day 28  </a:t>
                </a:r>
              </a:p>
            </p:txBody>
          </p:sp>
        </p:grp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1852C4F7-2B6C-6534-7114-BDEFA54DA6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9745" y="7132747"/>
            <a:ext cx="1850701" cy="259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3268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884B9CF-EEC4-2D17-E592-62BDECCB7DDA}"/>
              </a:ext>
            </a:extLst>
          </p:cNvPr>
          <p:cNvGrpSpPr/>
          <p:nvPr/>
        </p:nvGrpSpPr>
        <p:grpSpPr>
          <a:xfrm>
            <a:off x="324341" y="2894045"/>
            <a:ext cx="7040730" cy="5041332"/>
            <a:chOff x="324341" y="5141945"/>
            <a:chExt cx="7040730" cy="5041332"/>
          </a:xfrm>
        </p:grpSpPr>
        <p:pic>
          <p:nvPicPr>
            <p:cNvPr id="3" name="Picture 2" descr="BioRender | Life Science Icons">
              <a:extLst>
                <a:ext uri="{FF2B5EF4-FFF2-40B4-BE49-F238E27FC236}">
                  <a16:creationId xmlns:a16="http://schemas.microsoft.com/office/drawing/2014/main" id="{02C47E27-8CFD-6537-171F-EC2C42309C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685"/>
            <a:stretch/>
          </p:blipFill>
          <p:spPr bwMode="auto">
            <a:xfrm>
              <a:off x="586322" y="5141945"/>
              <a:ext cx="2170041" cy="2578653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" name="Picture 36" descr="BioRender | Life Science Icons">
              <a:extLst>
                <a:ext uri="{FF2B5EF4-FFF2-40B4-BE49-F238E27FC236}">
                  <a16:creationId xmlns:a16="http://schemas.microsoft.com/office/drawing/2014/main" id="{87F15F42-4DD7-72A8-7791-29DB1B23450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686"/>
            <a:stretch>
              <a:fillRect/>
            </a:stretch>
          </p:blipFill>
          <p:spPr bwMode="auto">
            <a:xfrm>
              <a:off x="4391602" y="5246609"/>
              <a:ext cx="2170113" cy="2578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BCD7EA8-210D-D344-4817-6047CC86983C}"/>
                </a:ext>
              </a:extLst>
            </p:cNvPr>
            <p:cNvGrpSpPr/>
            <p:nvPr/>
          </p:nvGrpSpPr>
          <p:grpSpPr>
            <a:xfrm>
              <a:off x="324341" y="5507720"/>
              <a:ext cx="7040730" cy="4437395"/>
              <a:chOff x="324341" y="5507720"/>
              <a:chExt cx="7040730" cy="4437395"/>
            </a:xfrm>
          </p:grpSpPr>
          <p:sp>
            <p:nvSpPr>
              <p:cNvPr id="7" name="Text Box 2">
                <a:extLst>
                  <a:ext uri="{FF2B5EF4-FFF2-40B4-BE49-F238E27FC236}">
                    <a16:creationId xmlns:a16="http://schemas.microsoft.com/office/drawing/2014/main" id="{841ACA43-A116-7E27-4831-D639DB3ACE1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08097" y="6111973"/>
                <a:ext cx="1303422" cy="4362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X 4 Mice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 Box 2">
                <a:extLst>
                  <a:ext uri="{FF2B5EF4-FFF2-40B4-BE49-F238E27FC236}">
                    <a16:creationId xmlns:a16="http://schemas.microsoft.com/office/drawing/2014/main" id="{2F5CA1E4-015C-02CE-CA49-B607EA79F2B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97210" y="6215337"/>
                <a:ext cx="651393" cy="2304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Ventral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 Box 2">
                <a:extLst>
                  <a:ext uri="{FF2B5EF4-FFF2-40B4-BE49-F238E27FC236}">
                    <a16:creationId xmlns:a16="http://schemas.microsoft.com/office/drawing/2014/main" id="{B8A80CC8-C6A8-376A-276C-A66139F9AFB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72947" y="7177070"/>
                <a:ext cx="1097280" cy="4465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TX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0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מחבר חץ ישר 200">
                <a:extLst>
                  <a:ext uri="{FF2B5EF4-FFF2-40B4-BE49-F238E27FC236}">
                    <a16:creationId xmlns:a16="http://schemas.microsoft.com/office/drawing/2014/main" id="{8AE87525-3A70-48A1-8699-4CEFE0ED5E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72948" y="6755923"/>
                <a:ext cx="358104" cy="45717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 Box 2">
                <a:extLst>
                  <a:ext uri="{FF2B5EF4-FFF2-40B4-BE49-F238E27FC236}">
                    <a16:creationId xmlns:a16="http://schemas.microsoft.com/office/drawing/2014/main" id="{20D4BD92-E4D1-1EC8-3261-4D173AB3408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33956" y="6549281"/>
                <a:ext cx="358105" cy="2782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 Box 2">
                <a:extLst>
                  <a:ext uri="{FF2B5EF4-FFF2-40B4-BE49-F238E27FC236}">
                    <a16:creationId xmlns:a16="http://schemas.microsoft.com/office/drawing/2014/main" id="{86632E1B-2A87-42FE-F4E3-F916C6735F2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889839" y="6549249"/>
                <a:ext cx="202197" cy="2782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 dirty="0"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מחבר חץ ישר 200">
                <a:extLst>
                  <a:ext uri="{FF2B5EF4-FFF2-40B4-BE49-F238E27FC236}">
                    <a16:creationId xmlns:a16="http://schemas.microsoft.com/office/drawing/2014/main" id="{61633A56-9094-173D-2BAD-E93DDC128E2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28166" y="6756008"/>
                <a:ext cx="341845" cy="45719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37641B02-E37D-3BCF-5249-DD360CFBEB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41172" y="7720598"/>
                <a:ext cx="0" cy="3190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 Box 2">
                <a:extLst>
                  <a:ext uri="{FF2B5EF4-FFF2-40B4-BE49-F238E27FC236}">
                    <a16:creationId xmlns:a16="http://schemas.microsoft.com/office/drawing/2014/main" id="{C75DC66D-B5DA-E752-26A7-6A124284652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98924" y="8003261"/>
                <a:ext cx="1435734" cy="4465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F + </a:t>
                </a:r>
                <a:r>
                  <a:rPr lang="en-US" sz="1100" b="1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ipto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5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 Box 2">
                <a:extLst>
                  <a:ext uri="{FF2B5EF4-FFF2-40B4-BE49-F238E27FC236}">
                    <a16:creationId xmlns:a16="http://schemas.microsoft.com/office/drawing/2014/main" id="{10C31141-A9ED-8D4B-5F69-CE3EB1B0622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23" y="7177345"/>
                <a:ext cx="1041400" cy="4465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lang="en-I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</a:pP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sz="11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TX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0 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en-US" sz="1100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7" name="Text Box 2">
                <a:extLst>
                  <a:ext uri="{FF2B5EF4-FFF2-40B4-BE49-F238E27FC236}">
                    <a16:creationId xmlns:a16="http://schemas.microsoft.com/office/drawing/2014/main" id="{1D991A20-34A1-6F2A-E4EA-F232FB91674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23" y="6803750"/>
                <a:ext cx="841707" cy="278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lang="en-IL" sz="110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 Box 2">
                <a:extLst>
                  <a:ext uri="{FF2B5EF4-FFF2-40B4-BE49-F238E27FC236}">
                    <a16:creationId xmlns:a16="http://schemas.microsoft.com/office/drawing/2014/main" id="{00B93AE0-9D10-F159-5772-5C9B1FC1EA8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92513" y="6803750"/>
                <a:ext cx="841707" cy="278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900"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lang="en-IL" sz="110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 Box 2">
                <a:extLst>
                  <a:ext uri="{FF2B5EF4-FFF2-40B4-BE49-F238E27FC236}">
                    <a16:creationId xmlns:a16="http://schemas.microsoft.com/office/drawing/2014/main" id="{3E7EF5C5-BB31-189F-0E53-4AAC44F4559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38293" y="7633613"/>
                <a:ext cx="930303" cy="4566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ctr" anchorCtr="0">
                <a:noAutofit/>
              </a:bodyPr>
              <a:lstStyle>
                <a:defPPr>
                  <a:defRPr lang="en-US"/>
                </a:defPPr>
                <a:lvl1pPr>
                  <a:defRPr sz="900">
                    <a:solidFill>
                      <a:srgbClr val="FF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dirty="0">
                    <a:solidFill>
                      <a:schemeClr val="accent6">
                        <a:lumMod val="75000"/>
                      </a:schemeClr>
                    </a:solidFill>
                  </a:rPr>
                  <a:t>30-minute</a:t>
                </a:r>
                <a:endParaRPr lang="en-IL" dirty="0">
                  <a:solidFill>
                    <a:schemeClr val="accent6">
                      <a:lumMod val="75000"/>
                    </a:schemeClr>
                  </a:solidFill>
                </a:endParaRPr>
              </a:p>
              <a:p>
                <a:r>
                  <a:rPr lang="en-US" dirty="0">
                    <a:solidFill>
                      <a:schemeClr val="accent6">
                        <a:lumMod val="75000"/>
                      </a:schemeClr>
                    </a:solidFill>
                  </a:rPr>
                  <a:t>waiting period</a:t>
                </a:r>
                <a:endParaRPr lang="en-IL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20" name="Text Box 2">
                <a:extLst>
                  <a:ext uri="{FF2B5EF4-FFF2-40B4-BE49-F238E27FC236}">
                    <a16:creationId xmlns:a16="http://schemas.microsoft.com/office/drawing/2014/main" id="{001E7B1E-41D9-1673-51EC-2E362442AFF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061733" y="6111973"/>
                <a:ext cx="1303338" cy="441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4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X 4 Mice</a:t>
                </a:r>
                <a:endParaRPr kumimoji="0" lang="en-US" altLang="en-IL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" name="Text Box 86">
                <a:extLst>
                  <a:ext uri="{FF2B5EF4-FFF2-40B4-BE49-F238E27FC236}">
                    <a16:creationId xmlns:a16="http://schemas.microsoft.com/office/drawing/2014/main" id="{F5B39C5D-F812-BFEF-4FA3-FACA034925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222528" y="6337745"/>
                <a:ext cx="650875" cy="2301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Ventral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" name="Text Box 85">
                <a:extLst>
                  <a:ext uri="{FF2B5EF4-FFF2-40B4-BE49-F238E27FC236}">
                    <a16:creationId xmlns:a16="http://schemas.microsoft.com/office/drawing/2014/main" id="{8686EC47-DD11-6CEA-0E68-88314D8A1C1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25208" y="7298182"/>
                <a:ext cx="1096963" cy="457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kumimoji="0" lang="en-US" altLang="en-IL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kumimoji="0" lang="en-US" altLang="en-IL" sz="11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TX</a:t>
                </a:r>
                <a:r>
                  <a:rPr kumimoji="0" lang="en-US" altLang="en-IL" sz="11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0 </a:t>
                </a:r>
                <a:r>
                  <a:rPr kumimoji="0" lang="en-US" altLang="en-IL" sz="11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kumimoji="0" lang="en-US" altLang="en-IL" sz="11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)</a:t>
                </a:r>
                <a:endParaRPr kumimoji="0" lang="en-US" altLang="en-IL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cxnSp>
            <p:nvCxnSpPr>
              <p:cNvPr id="23" name="מחבר חץ ישר 200">
                <a:extLst>
                  <a:ext uri="{FF2B5EF4-FFF2-40B4-BE49-F238E27FC236}">
                    <a16:creationId xmlns:a16="http://schemas.microsoft.com/office/drawing/2014/main" id="{7077AF82-64D2-875F-219D-94BE2D7CEF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75130" y="6860667"/>
                <a:ext cx="357505" cy="45656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 Box 83">
                <a:extLst>
                  <a:ext uri="{FF2B5EF4-FFF2-40B4-BE49-F238E27FC236}">
                    <a16:creationId xmlns:a16="http://schemas.microsoft.com/office/drawing/2014/main" id="{A3C8AA18-C6F3-97D2-6A52-9CDCD1E6C59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044506" y="6671120"/>
                <a:ext cx="400077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" name="Text Box 82">
                <a:extLst>
                  <a:ext uri="{FF2B5EF4-FFF2-40B4-BE49-F238E27FC236}">
                    <a16:creationId xmlns:a16="http://schemas.microsoft.com/office/drawing/2014/main" id="{FE327888-6683-2296-BE1C-231DFAE5C91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695992" y="6671120"/>
                <a:ext cx="192388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rgbClr val="4472C4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cxnSp>
            <p:nvCxnSpPr>
              <p:cNvPr id="26" name="מחבר חץ ישר 200">
                <a:extLst>
                  <a:ext uri="{FF2B5EF4-FFF2-40B4-BE49-F238E27FC236}">
                    <a16:creationId xmlns:a16="http://schemas.microsoft.com/office/drawing/2014/main" id="{8B5B8639-D490-A60C-652E-028F293D37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730860" y="6860667"/>
                <a:ext cx="341630" cy="45656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E3B82C08-3D02-B04B-5492-AB09BDE0722E}"/>
                  </a:ext>
                </a:extLst>
              </p:cNvPr>
              <p:cNvCxnSpPr/>
              <p:nvPr/>
            </p:nvCxnSpPr>
            <p:spPr>
              <a:xfrm>
                <a:off x="6387691" y="7684938"/>
                <a:ext cx="0" cy="45656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 Box 79">
                <a:extLst>
                  <a:ext uri="{FF2B5EF4-FFF2-40B4-BE49-F238E27FC236}">
                    <a16:creationId xmlns:a16="http://schemas.microsoft.com/office/drawing/2014/main" id="{FB63C795-F37F-9F84-0C92-F8F5F8B20E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896633" y="8123682"/>
                <a:ext cx="1376363" cy="430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kumimoji="0" lang="en-US" altLang="en-IL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kumimoji="0" lang="en-US" altLang="en-IL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mpty PF</a:t>
                </a: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5 </a:t>
                </a:r>
                <a:r>
                  <a:rPr kumimoji="0" lang="en-US" altLang="en-IL" sz="1100" b="0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kumimoji="0" lang="en-US" altLang="en-IL" sz="1100" b="0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kumimoji="0" lang="en-US" altLang="en-IL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9" name="Text Box 78">
                <a:extLst>
                  <a:ext uri="{FF2B5EF4-FFF2-40B4-BE49-F238E27FC236}">
                    <a16:creationId xmlns:a16="http://schemas.microsoft.com/office/drawing/2014/main" id="{3EFAB440-5F12-77D2-0B53-1377DB7BD26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80558" y="6925120"/>
                <a:ext cx="841375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" name="Text Box 77">
                <a:extLst>
                  <a:ext uri="{FF2B5EF4-FFF2-40B4-BE49-F238E27FC236}">
                    <a16:creationId xmlns:a16="http://schemas.microsoft.com/office/drawing/2014/main" id="{1789332E-5D78-960C-CC7D-059D43383F9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044271" y="6925120"/>
                <a:ext cx="841375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nesthesia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" name="Text Box 76">
                <a:extLst>
                  <a:ext uri="{FF2B5EF4-FFF2-40B4-BE49-F238E27FC236}">
                    <a16:creationId xmlns:a16="http://schemas.microsoft.com/office/drawing/2014/main" id="{99434380-2415-ACDA-CC43-68B3A6DDD35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348529" y="7742616"/>
                <a:ext cx="930275" cy="457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30-minute</a:t>
                </a:r>
                <a:endParaRPr kumimoji="0" lang="en-US" altLang="en-IL" sz="400" b="0" i="0" u="none" strike="noStrike" cap="none" normalizeH="0" baseline="0" dirty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aiting period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" name="Text Box 75">
                <a:extLst>
                  <a:ext uri="{FF2B5EF4-FFF2-40B4-BE49-F238E27FC236}">
                    <a16:creationId xmlns:a16="http://schemas.microsoft.com/office/drawing/2014/main" id="{FF4DD829-8649-4842-B072-30DFD935C78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02783" y="7299770"/>
                <a:ext cx="1096963" cy="457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kumimoji="0" lang="en-US" altLang="en-IL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kumimoji="0" lang="en-US" altLang="en-IL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TX</a:t>
                </a: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0 </a:t>
                </a:r>
                <a:r>
                  <a:rPr kumimoji="0" lang="en-US" altLang="en-IL" sz="1100" b="0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kumimoji="0" lang="en-US" altLang="en-IL" sz="1100" b="0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" name="Text Box 74">
                <a:extLst>
                  <a:ext uri="{FF2B5EF4-FFF2-40B4-BE49-F238E27FC236}">
                    <a16:creationId xmlns:a16="http://schemas.microsoft.com/office/drawing/2014/main" id="{254AA05B-4557-6618-F48B-B6184379BE0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09069" y="8170172"/>
                <a:ext cx="1716087" cy="430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 injection</a:t>
                </a:r>
                <a:endParaRPr kumimoji="0" lang="en-US" altLang="en-IL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f </a:t>
                </a:r>
                <a:r>
                  <a:rPr kumimoji="0" lang="en-US" altLang="en-IL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olus </a:t>
                </a:r>
                <a:r>
                  <a:rPr kumimoji="0" lang="en-US" altLang="en-IL" sz="1100" b="1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ipto</a:t>
                </a: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(25 </a:t>
                </a:r>
                <a:r>
                  <a:rPr kumimoji="0" lang="en-US" altLang="en-IL" sz="1100" b="0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kumimoji="0" lang="en-US" altLang="en-IL" sz="1100" b="0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</a:t>
                </a:r>
                <a:r>
                  <a:rPr kumimoji="0" lang="en-US" altLang="en-IL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</a:t>
                </a:r>
                <a:endParaRPr kumimoji="0" lang="en-US" altLang="en-IL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D4738586-2941-5C77-A10B-2172ACCF7A29}"/>
                  </a:ext>
                </a:extLst>
              </p:cNvPr>
              <p:cNvCxnSpPr/>
              <p:nvPr/>
            </p:nvCxnSpPr>
            <p:spPr>
              <a:xfrm>
                <a:off x="4767712" y="7714742"/>
                <a:ext cx="0" cy="45656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 Box 72">
                <a:extLst>
                  <a:ext uri="{FF2B5EF4-FFF2-40B4-BE49-F238E27FC236}">
                    <a16:creationId xmlns:a16="http://schemas.microsoft.com/office/drawing/2014/main" id="{6BA2102D-C9DF-9C5D-229B-7A8FD2BA275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59492" y="7742616"/>
                <a:ext cx="930275" cy="457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30-minute</a:t>
                </a:r>
                <a:endParaRPr kumimoji="0" lang="en-US" altLang="en-IL" sz="400" b="0" i="0" u="none" strike="noStrike" cap="none" normalizeH="0" baseline="0" dirty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IL" sz="900" b="0" i="0" u="none" strike="noStrike" cap="none" normalizeH="0" baseline="0" dirty="0">
                    <a:ln>
                      <a:noFill/>
                    </a:ln>
                    <a:solidFill>
                      <a:schemeClr val="accent6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waiting period</a:t>
                </a:r>
                <a:endParaRPr kumimoji="0" lang="en-US" altLang="en-IL" sz="1800" b="0" i="0" u="none" strike="noStrike" cap="none" normalizeH="0" baseline="0" dirty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B45E7391-CE5F-BF65-D6F7-8F4B3EF6A027}"/>
                  </a:ext>
                </a:extLst>
              </p:cNvPr>
              <p:cNvSpPr/>
              <p:nvPr/>
            </p:nvSpPr>
            <p:spPr>
              <a:xfrm>
                <a:off x="324341" y="5507720"/>
                <a:ext cx="6910992" cy="4383614"/>
              </a:xfrm>
              <a:prstGeom prst="rect">
                <a:avLst/>
              </a:prstGeom>
              <a:noFill/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L"/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8D1B12DE-6D12-315D-FF80-21FB101A8401}"/>
                  </a:ext>
                </a:extLst>
              </p:cNvPr>
              <p:cNvCxnSpPr/>
              <p:nvPr/>
            </p:nvCxnSpPr>
            <p:spPr>
              <a:xfrm>
                <a:off x="580463" y="9209916"/>
                <a:ext cx="6326426" cy="0"/>
              </a:xfrm>
              <a:prstGeom prst="line">
                <a:avLst/>
              </a:prstGeom>
              <a:ln w="127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7BF23B6-12B5-789F-054A-830CC241FFF4}"/>
                  </a:ext>
                </a:extLst>
              </p:cNvPr>
              <p:cNvSpPr txBox="1"/>
              <p:nvPr/>
            </p:nvSpPr>
            <p:spPr>
              <a:xfrm>
                <a:off x="327689" y="8622530"/>
                <a:ext cx="1428692" cy="54309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roup 1: Untreated</a:t>
                </a:r>
                <a:endParaRPr lang="en-IL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00A2464-06BD-FD20-6BD4-172098D52508}"/>
                  </a:ext>
                </a:extLst>
              </p:cNvPr>
              <p:cNvSpPr txBox="1"/>
              <p:nvPr/>
            </p:nvSpPr>
            <p:spPr>
              <a:xfrm>
                <a:off x="2151108" y="8621377"/>
                <a:ext cx="969480" cy="54309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roup 2: PF-</a:t>
                </a:r>
                <a:r>
                  <a:rPr lang="en-US" sz="1400" b="1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ipto</a:t>
                </a:r>
                <a:endParaRPr lang="en-IL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A8E308F-5A36-A39D-8E68-BE11B918A2BE}"/>
                  </a:ext>
                </a:extLst>
              </p:cNvPr>
              <p:cNvSpPr txBox="1"/>
              <p:nvPr/>
            </p:nvSpPr>
            <p:spPr>
              <a:xfrm>
                <a:off x="4344000" y="8626344"/>
                <a:ext cx="1148560" cy="54309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roup 3: Bolus-</a:t>
                </a:r>
                <a:r>
                  <a:rPr lang="en-US" sz="1400" b="1" dirty="0" err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ripto</a:t>
                </a:r>
                <a:endParaRPr lang="en-IL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DCBCF644-938B-EFE0-7F07-2B3103E0ABB9}"/>
                  </a:ext>
                </a:extLst>
              </p:cNvPr>
              <p:cNvSpPr txBox="1"/>
              <p:nvPr/>
            </p:nvSpPr>
            <p:spPr>
              <a:xfrm>
                <a:off x="6193880" y="8626146"/>
                <a:ext cx="902300" cy="54309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roup 4: Empty PF</a:t>
                </a:r>
                <a:endParaRPr lang="en-IL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 Box 2">
                <a:extLst>
                  <a:ext uri="{FF2B5EF4-FFF2-40B4-BE49-F238E27FC236}">
                    <a16:creationId xmlns:a16="http://schemas.microsoft.com/office/drawing/2014/main" id="{50EEBBC9-E2C5-CFDD-22E9-2770568D44B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48192" y="9488479"/>
                <a:ext cx="2645774" cy="456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ctr" anchorCtr="0">
                <a:noAutofit/>
              </a:bodyPr>
              <a:lstStyle/>
              <a:p>
                <a:pPr algn="ctr"/>
                <a:r>
                  <a:rPr lang="en-IL" sz="1400" dirty="0">
                    <a:solidFill>
                      <a:srgbClr val="FF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Sacrafice at day 7 and day 23</a:t>
                </a:r>
              </a:p>
            </p:txBody>
          </p: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8184D1CF-FE4B-D9C4-BD68-E2EB89036497}"/>
                  </a:ext>
                </a:extLst>
              </p:cNvPr>
              <p:cNvCxnSpPr/>
              <p:nvPr/>
            </p:nvCxnSpPr>
            <p:spPr>
              <a:xfrm>
                <a:off x="580463" y="9555445"/>
                <a:ext cx="6326426" cy="0"/>
              </a:xfrm>
              <a:prstGeom prst="line">
                <a:avLst/>
              </a:prstGeom>
              <a:ln w="127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 Box 2">
                <a:extLst>
                  <a:ext uri="{FF2B5EF4-FFF2-40B4-BE49-F238E27FC236}">
                    <a16:creationId xmlns:a16="http://schemas.microsoft.com/office/drawing/2014/main" id="{FD0F8AAA-4017-617F-856A-1BB17B0F34A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9223" y="9144208"/>
                <a:ext cx="6770080" cy="4566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ctr" anchorCtr="0">
                <a:noAutofit/>
              </a:bodyPr>
              <a:lstStyle/>
              <a:p>
                <a:pPr algn="ctr"/>
                <a:r>
                  <a:rPr lang="en-IL" sz="1400" b="1" dirty="0">
                    <a:solidFill>
                      <a:schemeClr val="accent2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Histological assessments: H&amp;E; </a:t>
                </a:r>
                <a:r>
                  <a:rPr lang="en-US" sz="1400" b="1" dirty="0">
                    <a:solidFill>
                      <a:schemeClr val="accent2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munofluorescence</a:t>
                </a:r>
                <a:r>
                  <a:rPr lang="en-IL" sz="1400" b="1" dirty="0">
                    <a:solidFill>
                      <a:schemeClr val="accent2">
                        <a:lumMod val="75000"/>
                      </a:schemeClr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for eMHC, Laminin, Desmin, Pax7</a:t>
                </a:r>
              </a:p>
            </p:txBody>
          </p:sp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984BAC8-8EB4-1863-18E8-E4F98F6279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99745" y="9923418"/>
              <a:ext cx="1850701" cy="259859"/>
            </a:xfrm>
            <a:prstGeom prst="rect">
              <a:avLst/>
            </a:prstGeom>
          </p:spPr>
        </p:pic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EE5B4457-0497-EBD6-E596-3BB70E77D5AD}"/>
              </a:ext>
            </a:extLst>
          </p:cNvPr>
          <p:cNvSpPr txBox="1"/>
          <p:nvPr/>
        </p:nvSpPr>
        <p:spPr>
          <a:xfrm>
            <a:off x="270728" y="177863"/>
            <a:ext cx="3571169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2</a:t>
            </a:r>
            <a:endParaRPr lang="he-IL" sz="2115" b="1" dirty="0"/>
          </a:p>
        </p:txBody>
      </p:sp>
    </p:spTree>
    <p:extLst>
      <p:ext uri="{BB962C8B-B14F-4D97-AF65-F5344CB8AC3E}">
        <p14:creationId xmlns:p14="http://schemas.microsoft.com/office/powerpoint/2010/main" val="28852673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6F0F70D-147E-778A-F008-8D8910AC5A6C}"/>
              </a:ext>
            </a:extLst>
          </p:cNvPr>
          <p:cNvSpPr txBox="1"/>
          <p:nvPr/>
        </p:nvSpPr>
        <p:spPr>
          <a:xfrm>
            <a:off x="257080" y="239517"/>
            <a:ext cx="3522757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3</a:t>
            </a:r>
            <a:endParaRPr lang="he-IL" sz="2115" b="1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FE2D5E7C-15F8-B3CD-B32C-1B4828154D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0197408"/>
              </p:ext>
            </p:extLst>
          </p:nvPr>
        </p:nvGraphicFramePr>
        <p:xfrm>
          <a:off x="1019431" y="3822661"/>
          <a:ext cx="5006254" cy="34817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50B117E-6116-0E26-F2DE-28EAAEEA0C38}"/>
              </a:ext>
            </a:extLst>
          </p:cNvPr>
          <p:cNvSpPr txBox="1"/>
          <p:nvPr/>
        </p:nvSpPr>
        <p:spPr>
          <a:xfrm>
            <a:off x="2438551" y="4208649"/>
            <a:ext cx="1114497" cy="211203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36000" rtlCol="0">
            <a:spAutoFit/>
          </a:bodyPr>
          <a:lstStyle/>
          <a:p>
            <a:r>
              <a:rPr lang="en-US" sz="900" b="1" dirty="0"/>
              <a:t>Low cross-linked P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73073EA-5045-1190-9A55-A77584F828B2}"/>
              </a:ext>
            </a:extLst>
          </p:cNvPr>
          <p:cNvSpPr txBox="1"/>
          <p:nvPr/>
        </p:nvSpPr>
        <p:spPr>
          <a:xfrm>
            <a:off x="2431463" y="4475448"/>
            <a:ext cx="1248358" cy="211203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36000" rtlCol="0">
            <a:spAutoFit/>
          </a:bodyPr>
          <a:lstStyle/>
          <a:p>
            <a:r>
              <a:rPr lang="en-US" sz="900" b="1" dirty="0"/>
              <a:t>High cross-linked PF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6A31A5D0-D29A-8AEE-CB37-B4212CE701E3}"/>
              </a:ext>
            </a:extLst>
          </p:cNvPr>
          <p:cNvCxnSpPr/>
          <p:nvPr/>
        </p:nvCxnSpPr>
        <p:spPr>
          <a:xfrm>
            <a:off x="3125586" y="6143105"/>
            <a:ext cx="0" cy="241069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7C28C4C-4236-3145-6AA2-D1B794399490}"/>
              </a:ext>
            </a:extLst>
          </p:cNvPr>
          <p:cNvSpPr txBox="1"/>
          <p:nvPr/>
        </p:nvSpPr>
        <p:spPr>
          <a:xfrm>
            <a:off x="2842956" y="5902013"/>
            <a:ext cx="565259" cy="211203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36000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UV light on</a:t>
            </a:r>
          </a:p>
        </p:txBody>
      </p:sp>
    </p:spTree>
    <p:extLst>
      <p:ext uri="{BB962C8B-B14F-4D97-AF65-F5344CB8AC3E}">
        <p14:creationId xmlns:p14="http://schemas.microsoft.com/office/powerpoint/2010/main" val="7459844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EC41640-22F1-14A0-B411-A3457F969B93}"/>
              </a:ext>
            </a:extLst>
          </p:cNvPr>
          <p:cNvGrpSpPr/>
          <p:nvPr/>
        </p:nvGrpSpPr>
        <p:grpSpPr>
          <a:xfrm>
            <a:off x="901703" y="3186589"/>
            <a:ext cx="5138608" cy="3900012"/>
            <a:chOff x="2337508" y="4386738"/>
            <a:chExt cx="2537422" cy="192580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4BADA3A-BE6D-4596-BF28-25B5AA143FE6}"/>
                </a:ext>
              </a:extLst>
            </p:cNvPr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06" r="36215"/>
            <a:stretch/>
          </p:blipFill>
          <p:spPr bwMode="auto">
            <a:xfrm>
              <a:off x="2778039" y="4386738"/>
              <a:ext cx="2096891" cy="191833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BC74321B-D26F-CBF4-3ED7-94BA64D11931}"/>
                </a:ext>
              </a:extLst>
            </p:cNvPr>
            <p:cNvPicPr/>
            <p:nvPr/>
          </p:nvPicPr>
          <p:blipFill rotWithShape="1">
            <a:blip r:embed="rId2">
              <a:clrChange>
                <a:clrFrom>
                  <a:srgbClr val="000000">
                    <a:alpha val="0"/>
                  </a:srgbClr>
                </a:clrFrom>
                <a:clrTo>
                  <a:srgbClr val="000000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0588"/>
            <a:stretch/>
          </p:blipFill>
          <p:spPr bwMode="auto">
            <a:xfrm>
              <a:off x="2337508" y="4394212"/>
              <a:ext cx="430168" cy="191833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11123621-5F1D-34E3-4B40-B77FAD1D607E}"/>
                </a:ext>
              </a:extLst>
            </p:cNvPr>
            <p:cNvCxnSpPr/>
            <p:nvPr/>
          </p:nvCxnSpPr>
          <p:spPr>
            <a:xfrm flipV="1">
              <a:off x="2760621" y="4394212"/>
              <a:ext cx="0" cy="1910861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47E23EF-D726-09AD-65CD-6CB0A72E75F8}"/>
              </a:ext>
            </a:extLst>
          </p:cNvPr>
          <p:cNvSpPr txBox="1"/>
          <p:nvPr/>
        </p:nvSpPr>
        <p:spPr>
          <a:xfrm>
            <a:off x="257080" y="239517"/>
            <a:ext cx="3522757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4</a:t>
            </a:r>
            <a:endParaRPr lang="he-IL" sz="2115" b="1" dirty="0"/>
          </a:p>
        </p:txBody>
      </p:sp>
    </p:spTree>
    <p:extLst>
      <p:ext uri="{BB962C8B-B14F-4D97-AF65-F5344CB8AC3E}">
        <p14:creationId xmlns:p14="http://schemas.microsoft.com/office/powerpoint/2010/main" val="38914660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A24032F-ECFE-42D7-30E5-68DBB756DEF7}"/>
              </a:ext>
            </a:extLst>
          </p:cNvPr>
          <p:cNvSpPr txBox="1"/>
          <p:nvPr/>
        </p:nvSpPr>
        <p:spPr>
          <a:xfrm>
            <a:off x="257080" y="239517"/>
            <a:ext cx="3522757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5</a:t>
            </a:r>
            <a:endParaRPr lang="he-IL" sz="2115" b="1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F264F8A-F9E8-2B1D-D835-12BA5CEA93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5968973"/>
              </p:ext>
            </p:extLst>
          </p:nvPr>
        </p:nvGraphicFramePr>
        <p:xfrm>
          <a:off x="939783" y="2886571"/>
          <a:ext cx="5615940" cy="597282"/>
        </p:xfrm>
        <a:graphic>
          <a:graphicData uri="http://schemas.openxmlformats.org/drawingml/2006/table">
            <a:tbl>
              <a:tblPr firstRow="1" firstCol="1" bandRow="1"/>
              <a:tblGrid>
                <a:gridCol w="1403985">
                  <a:extLst>
                    <a:ext uri="{9D8B030D-6E8A-4147-A177-3AD203B41FA5}">
                      <a16:colId xmlns:a16="http://schemas.microsoft.com/office/drawing/2014/main" val="2827252201"/>
                    </a:ext>
                  </a:extLst>
                </a:gridCol>
                <a:gridCol w="1403985">
                  <a:extLst>
                    <a:ext uri="{9D8B030D-6E8A-4147-A177-3AD203B41FA5}">
                      <a16:colId xmlns:a16="http://schemas.microsoft.com/office/drawing/2014/main" val="3400819198"/>
                    </a:ext>
                  </a:extLst>
                </a:gridCol>
                <a:gridCol w="1403985">
                  <a:extLst>
                    <a:ext uri="{9D8B030D-6E8A-4147-A177-3AD203B41FA5}">
                      <a16:colId xmlns:a16="http://schemas.microsoft.com/office/drawing/2014/main" val="2579818102"/>
                    </a:ext>
                  </a:extLst>
                </a:gridCol>
                <a:gridCol w="1403985">
                  <a:extLst>
                    <a:ext uri="{9D8B030D-6E8A-4147-A177-3AD203B41FA5}">
                      <a16:colId xmlns:a16="http://schemas.microsoft.com/office/drawing/2014/main" val="236515120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indent="0" algn="ctr" defTabSz="755934" rtl="1" eaLnBrk="1" fontAlgn="auto" latinLnBrk="0" hangingPunct="1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ow cross-linked   PF microspher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755934" rtl="1" eaLnBrk="1" fontAlgn="auto" latinLnBrk="0" hangingPunct="1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igh cross-linked   PF microspher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Untreate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ree Cripto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63187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ctr" defTabSz="755934" rtl="0" eaLnBrk="1" latinLnBrk="0" hangingPunct="1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755934" rtl="0" eaLnBrk="1" latinLnBrk="0" hangingPunct="1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755934" rtl="0" eaLnBrk="1" latinLnBrk="0" hangingPunct="1">
                        <a:lnSpc>
                          <a:spcPct val="115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5088021"/>
                  </a:ext>
                </a:extLst>
              </a:tr>
            </a:tbl>
          </a:graphicData>
        </a:graphic>
      </p:graphicFrame>
      <p:grpSp>
        <p:nvGrpSpPr>
          <p:cNvPr id="4" name="Group 3">
            <a:extLst>
              <a:ext uri="{FF2B5EF4-FFF2-40B4-BE49-F238E27FC236}">
                <a16:creationId xmlns:a16="http://schemas.microsoft.com/office/drawing/2014/main" id="{521ADA3B-94DC-DE75-484B-D2D530F302E9}"/>
              </a:ext>
            </a:extLst>
          </p:cNvPr>
          <p:cNvGrpSpPr/>
          <p:nvPr/>
        </p:nvGrpSpPr>
        <p:grpSpPr>
          <a:xfrm>
            <a:off x="901272" y="3351012"/>
            <a:ext cx="5686854" cy="1371600"/>
            <a:chOff x="901272" y="5385221"/>
            <a:chExt cx="5686854" cy="1371600"/>
          </a:xfrm>
        </p:grpSpPr>
        <p:pic>
          <p:nvPicPr>
            <p:cNvPr id="5" name="Picture 356" descr="Ax5">
              <a:extLst>
                <a:ext uri="{FF2B5EF4-FFF2-40B4-BE49-F238E27FC236}">
                  <a16:creationId xmlns:a16="http://schemas.microsoft.com/office/drawing/2014/main" id="{3B52CC87-7297-C047-D8FF-FB0CC28AF8E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1272" y="5385221"/>
              <a:ext cx="137160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57" descr="Bx5">
              <a:extLst>
                <a:ext uri="{FF2B5EF4-FFF2-40B4-BE49-F238E27FC236}">
                  <a16:creationId xmlns:a16="http://schemas.microsoft.com/office/drawing/2014/main" id="{499E49D5-DA23-2018-346D-5C069B16F5B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3149" y="5385221"/>
              <a:ext cx="137160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361" descr="Fx5">
              <a:extLst>
                <a:ext uri="{FF2B5EF4-FFF2-40B4-BE49-F238E27FC236}">
                  <a16:creationId xmlns:a16="http://schemas.microsoft.com/office/drawing/2014/main" id="{AF0C4008-DEE4-166E-8B6D-D6FD4BB3767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9837" y="5385221"/>
              <a:ext cx="137160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362" descr="Gx5">
              <a:extLst>
                <a:ext uri="{FF2B5EF4-FFF2-40B4-BE49-F238E27FC236}">
                  <a16:creationId xmlns:a16="http://schemas.microsoft.com/office/drawing/2014/main" id="{AE0AAB94-81BD-F93A-77CD-D4D1635853E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16526" y="5385221"/>
              <a:ext cx="137160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D31CC6A6-ACEA-11AA-0CE9-2905A9C37EB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7080" y="5433717"/>
            <a:ext cx="3547427" cy="196064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394A1E4-467B-E9F9-F8EC-550C7408F8E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04507" y="5264770"/>
            <a:ext cx="3498088" cy="2204505"/>
          </a:xfrm>
          <a:prstGeom prst="rect">
            <a:avLst/>
          </a:prstGeom>
        </p:spPr>
      </p:pic>
      <p:sp>
        <p:nvSpPr>
          <p:cNvPr id="11" name="Text Box 2">
            <a:extLst>
              <a:ext uri="{FF2B5EF4-FFF2-40B4-BE49-F238E27FC236}">
                <a16:creationId xmlns:a16="http://schemas.microsoft.com/office/drawing/2014/main" id="{676047FD-DA78-450E-389F-C051AB55DD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609" y="2743696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2">
            <a:extLst>
              <a:ext uri="{FF2B5EF4-FFF2-40B4-BE49-F238E27FC236}">
                <a16:creationId xmlns:a16="http://schemas.microsoft.com/office/drawing/2014/main" id="{90081E04-3ABC-0836-7313-66B2E34270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598" y="4969031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2">
            <a:extLst>
              <a:ext uri="{FF2B5EF4-FFF2-40B4-BE49-F238E27FC236}">
                <a16:creationId xmlns:a16="http://schemas.microsoft.com/office/drawing/2014/main" id="{0B91B96A-B679-A52C-2CC9-E9415E364A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0014" y="4964072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D4B1257A-3ED7-DDAB-0C19-D6927F647F5D}"/>
              </a:ext>
            </a:extLst>
          </p:cNvPr>
          <p:cNvGrpSpPr/>
          <p:nvPr/>
        </p:nvGrpSpPr>
        <p:grpSpPr>
          <a:xfrm>
            <a:off x="703033" y="7098389"/>
            <a:ext cx="3152096" cy="345201"/>
            <a:chOff x="703033" y="5849040"/>
            <a:chExt cx="3152096" cy="345201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CA0C841-DA56-66A4-5E34-017093CDBE8A}"/>
                </a:ext>
              </a:extLst>
            </p:cNvPr>
            <p:cNvSpPr txBox="1"/>
            <p:nvPr/>
          </p:nvSpPr>
          <p:spPr>
            <a:xfrm>
              <a:off x="703033" y="5854331"/>
              <a:ext cx="88403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PF microspheres G’=1600Pa</a:t>
              </a:r>
              <a:endParaRPr lang="he-IL" sz="800" b="1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09FB80E-FFEE-79C0-85FE-CCF656F6281F}"/>
                </a:ext>
              </a:extLst>
            </p:cNvPr>
            <p:cNvSpPr txBox="1"/>
            <p:nvPr/>
          </p:nvSpPr>
          <p:spPr>
            <a:xfrm>
              <a:off x="1499609" y="5854331"/>
              <a:ext cx="88403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PF microspheres G’=3500Pa</a:t>
              </a:r>
              <a:endParaRPr lang="he-IL" sz="8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B2CC568-3826-AEAC-0C1C-547ED80E8A9D}"/>
                </a:ext>
              </a:extLst>
            </p:cNvPr>
            <p:cNvSpPr txBox="1"/>
            <p:nvPr/>
          </p:nvSpPr>
          <p:spPr>
            <a:xfrm>
              <a:off x="2279081" y="5849040"/>
              <a:ext cx="88403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Untreated</a:t>
              </a:r>
              <a:endParaRPr lang="he-IL" sz="800" b="1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7258F93-1F4C-49FF-F2A1-67A4D611253B}"/>
                </a:ext>
              </a:extLst>
            </p:cNvPr>
            <p:cNvSpPr txBox="1"/>
            <p:nvPr/>
          </p:nvSpPr>
          <p:spPr>
            <a:xfrm>
              <a:off x="2971090" y="5855687"/>
              <a:ext cx="88403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Free </a:t>
              </a:r>
              <a:r>
                <a:rPr lang="en-US" sz="800" b="1" dirty="0" err="1"/>
                <a:t>Cripto</a:t>
              </a:r>
              <a:endParaRPr lang="en-US" sz="800" b="1" dirty="0"/>
            </a:p>
            <a:p>
              <a:pPr algn="ctr"/>
              <a:endParaRPr lang="he-IL" sz="800" b="1" dirty="0"/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C0644D0-8E61-4F39-A7C2-2DBD409E9F86}"/>
              </a:ext>
            </a:extLst>
          </p:cNvPr>
          <p:cNvGrpSpPr/>
          <p:nvPr/>
        </p:nvGrpSpPr>
        <p:grpSpPr>
          <a:xfrm>
            <a:off x="4242509" y="7079192"/>
            <a:ext cx="3152096" cy="345201"/>
            <a:chOff x="703033" y="5849040"/>
            <a:chExt cx="3152096" cy="345201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104698C-4A48-7C7A-327D-BDF3F692AA1D}"/>
                </a:ext>
              </a:extLst>
            </p:cNvPr>
            <p:cNvSpPr txBox="1"/>
            <p:nvPr/>
          </p:nvSpPr>
          <p:spPr>
            <a:xfrm>
              <a:off x="703033" y="5854331"/>
              <a:ext cx="88403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PF microspheres G’=1600Pa</a:t>
              </a:r>
              <a:endParaRPr lang="he-IL" sz="800" b="1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290C3BD-BC88-07CC-CE51-B13309E7F31F}"/>
                </a:ext>
              </a:extLst>
            </p:cNvPr>
            <p:cNvSpPr txBox="1"/>
            <p:nvPr/>
          </p:nvSpPr>
          <p:spPr>
            <a:xfrm>
              <a:off x="1499609" y="5854331"/>
              <a:ext cx="88403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PF microspheres G’=3500Pa</a:t>
              </a:r>
              <a:endParaRPr lang="he-IL" sz="800" b="1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C44FE22-2318-92FC-9CE7-B6D55764A993}"/>
                </a:ext>
              </a:extLst>
            </p:cNvPr>
            <p:cNvSpPr txBox="1"/>
            <p:nvPr/>
          </p:nvSpPr>
          <p:spPr>
            <a:xfrm>
              <a:off x="2279081" y="5849040"/>
              <a:ext cx="88403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Untreated</a:t>
              </a:r>
              <a:endParaRPr lang="he-IL" sz="800" b="1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D1D1DCD-201D-CD53-4B2D-027EC2FD4C58}"/>
                </a:ext>
              </a:extLst>
            </p:cNvPr>
            <p:cNvSpPr txBox="1"/>
            <p:nvPr/>
          </p:nvSpPr>
          <p:spPr>
            <a:xfrm>
              <a:off x="2971090" y="5855687"/>
              <a:ext cx="88403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800" b="1" dirty="0"/>
                <a:t>Free </a:t>
              </a:r>
              <a:r>
                <a:rPr lang="en-US" sz="800" b="1" dirty="0" err="1"/>
                <a:t>Cripto</a:t>
              </a:r>
              <a:endParaRPr lang="en-US" sz="800" b="1" dirty="0"/>
            </a:p>
            <a:p>
              <a:pPr algn="ctr"/>
              <a:endParaRPr lang="he-IL" sz="800" b="1" dirty="0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CDF9463E-E4BF-D579-D2B5-402FA8654B04}"/>
              </a:ext>
            </a:extLst>
          </p:cNvPr>
          <p:cNvSpPr txBox="1"/>
          <p:nvPr/>
        </p:nvSpPr>
        <p:spPr>
          <a:xfrm>
            <a:off x="748713" y="7122076"/>
            <a:ext cx="786003" cy="349702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36000" rtlCol="0">
            <a:spAutoFit/>
          </a:bodyPr>
          <a:lstStyle/>
          <a:p>
            <a:pPr algn="ctr"/>
            <a:r>
              <a:rPr lang="en-US" sz="900" b="1" dirty="0"/>
              <a:t>Low cross-</a:t>
            </a:r>
          </a:p>
          <a:p>
            <a:pPr algn="ctr"/>
            <a:r>
              <a:rPr lang="en-US" sz="900" b="1" dirty="0"/>
              <a:t>linked P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A506B34-A450-4B22-B958-97557BF7701B}"/>
              </a:ext>
            </a:extLst>
          </p:cNvPr>
          <p:cNvSpPr txBox="1"/>
          <p:nvPr/>
        </p:nvSpPr>
        <p:spPr>
          <a:xfrm>
            <a:off x="1483902" y="7122076"/>
            <a:ext cx="806339" cy="349702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36000" rtlCol="0">
            <a:spAutoFit/>
          </a:bodyPr>
          <a:lstStyle/>
          <a:p>
            <a:pPr algn="ctr"/>
            <a:r>
              <a:rPr lang="en-US" sz="900" b="1" dirty="0"/>
              <a:t>High cross-</a:t>
            </a:r>
          </a:p>
          <a:p>
            <a:pPr algn="ctr"/>
            <a:r>
              <a:rPr lang="en-US" sz="900" b="1" dirty="0"/>
              <a:t>linked PF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04BE9DA-AAE6-F02D-8469-3B15C397FED2}"/>
              </a:ext>
            </a:extLst>
          </p:cNvPr>
          <p:cNvSpPr txBox="1"/>
          <p:nvPr/>
        </p:nvSpPr>
        <p:spPr>
          <a:xfrm>
            <a:off x="4288188" y="7088283"/>
            <a:ext cx="786003" cy="349702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36000" rtlCol="0">
            <a:spAutoFit/>
          </a:bodyPr>
          <a:lstStyle/>
          <a:p>
            <a:pPr algn="ctr"/>
            <a:r>
              <a:rPr lang="en-US" sz="900" b="1" dirty="0"/>
              <a:t>Low cross-</a:t>
            </a:r>
          </a:p>
          <a:p>
            <a:pPr algn="ctr"/>
            <a:r>
              <a:rPr lang="en-US" sz="900" b="1" dirty="0"/>
              <a:t>linked P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D7F1F10-C7C8-4BAD-5908-A10D6BDBF6C0}"/>
              </a:ext>
            </a:extLst>
          </p:cNvPr>
          <p:cNvSpPr txBox="1"/>
          <p:nvPr/>
        </p:nvSpPr>
        <p:spPr>
          <a:xfrm>
            <a:off x="5023377" y="7088283"/>
            <a:ext cx="806339" cy="349702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36000" rtlCol="0">
            <a:spAutoFit/>
          </a:bodyPr>
          <a:lstStyle/>
          <a:p>
            <a:pPr algn="ctr"/>
            <a:r>
              <a:rPr lang="en-US" sz="900" b="1" dirty="0"/>
              <a:t>High cross-</a:t>
            </a:r>
          </a:p>
          <a:p>
            <a:pPr algn="ctr"/>
            <a:r>
              <a:rPr lang="en-US" sz="900" b="1" dirty="0"/>
              <a:t>linked PF</a:t>
            </a:r>
          </a:p>
        </p:txBody>
      </p:sp>
    </p:spTree>
    <p:extLst>
      <p:ext uri="{BB962C8B-B14F-4D97-AF65-F5344CB8AC3E}">
        <p14:creationId xmlns:p14="http://schemas.microsoft.com/office/powerpoint/2010/main" val="10297723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796A3F4A-0868-132B-1E05-7341B5ECE66E}"/>
              </a:ext>
            </a:extLst>
          </p:cNvPr>
          <p:cNvGrpSpPr/>
          <p:nvPr/>
        </p:nvGrpSpPr>
        <p:grpSpPr>
          <a:xfrm>
            <a:off x="80746" y="3405102"/>
            <a:ext cx="7398182" cy="3037776"/>
            <a:chOff x="78989" y="1064074"/>
            <a:chExt cx="7398182" cy="3037776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A51E70A-5087-A624-BA9C-EDCF984327C1}"/>
                </a:ext>
              </a:extLst>
            </p:cNvPr>
            <p:cNvSpPr txBox="1"/>
            <p:nvPr/>
          </p:nvSpPr>
          <p:spPr>
            <a:xfrm>
              <a:off x="270729" y="1064074"/>
              <a:ext cx="679994" cy="2031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D6B74AD-A8D8-E89A-7974-BB2A70BCD26B}"/>
                </a:ext>
              </a:extLst>
            </p:cNvPr>
            <p:cNvSpPr txBox="1"/>
            <p:nvPr/>
          </p:nvSpPr>
          <p:spPr>
            <a:xfrm>
              <a:off x="1287340" y="1064074"/>
              <a:ext cx="679994" cy="2031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4D38A5A-36C2-203E-E392-BD8B778E417A}"/>
                </a:ext>
              </a:extLst>
            </p:cNvPr>
            <p:cNvSpPr txBox="1"/>
            <p:nvPr/>
          </p:nvSpPr>
          <p:spPr>
            <a:xfrm>
              <a:off x="2369242" y="1064074"/>
              <a:ext cx="679994" cy="2031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2016264-6775-EE19-96BA-0211558504D8}"/>
                </a:ext>
              </a:extLst>
            </p:cNvPr>
            <p:cNvSpPr txBox="1"/>
            <p:nvPr/>
          </p:nvSpPr>
          <p:spPr>
            <a:xfrm>
              <a:off x="3394434" y="1064074"/>
              <a:ext cx="679994" cy="2031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6CC9306-63DE-7FC9-AAA9-5BCAF6C4181C}"/>
                </a:ext>
              </a:extLst>
            </p:cNvPr>
            <p:cNvSpPr txBox="1"/>
            <p:nvPr/>
          </p:nvSpPr>
          <p:spPr>
            <a:xfrm>
              <a:off x="4483795" y="1064074"/>
              <a:ext cx="782587" cy="2031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</a:t>
              </a:r>
              <a:r>
                <a:rPr lang="he-IL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DBCF483-81D4-06C3-3C3B-7AC7821EC669}"/>
                </a:ext>
              </a:extLst>
            </p:cNvPr>
            <p:cNvSpPr txBox="1"/>
            <p:nvPr/>
          </p:nvSpPr>
          <p:spPr>
            <a:xfrm>
              <a:off x="5531369" y="1064074"/>
              <a:ext cx="782587" cy="2031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2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E2AA0BF-804E-FCC5-6F96-8C9101F012CF}"/>
                </a:ext>
              </a:extLst>
            </p:cNvPr>
            <p:cNvSpPr txBox="1"/>
            <p:nvPr/>
          </p:nvSpPr>
          <p:spPr>
            <a:xfrm>
              <a:off x="6578941" y="1064074"/>
              <a:ext cx="782587" cy="2031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28</a:t>
              </a:r>
            </a:p>
          </p:txBody>
        </p: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6CB0F751-E79A-3A93-4307-7EA184784225}"/>
                </a:ext>
              </a:extLst>
            </p:cNvPr>
            <p:cNvGrpSpPr/>
            <p:nvPr/>
          </p:nvGrpSpPr>
          <p:grpSpPr>
            <a:xfrm>
              <a:off x="78989" y="1433411"/>
              <a:ext cx="7398182" cy="2668439"/>
              <a:chOff x="30863" y="1096529"/>
              <a:chExt cx="7398182" cy="2668439"/>
            </a:xfrm>
          </p:grpSpPr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0FA051A7-249F-0042-812A-C062A7BC51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2500" t="14268" r="12500" b="9504"/>
              <a:stretch/>
            </p:blipFill>
            <p:spPr>
              <a:xfrm>
                <a:off x="30863" y="1096583"/>
                <a:ext cx="1028701" cy="1316731"/>
              </a:xfrm>
              <a:prstGeom prst="rect">
                <a:avLst/>
              </a:prstGeom>
            </p:spPr>
          </p:pic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ED32BDA9-7A7A-6461-22F1-D02314C890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708" t="15636" r="2700" b="15636"/>
              <a:stretch/>
            </p:blipFill>
            <p:spPr>
              <a:xfrm>
                <a:off x="1092443" y="1096529"/>
                <a:ext cx="1028711" cy="1316798"/>
              </a:xfrm>
              <a:prstGeom prst="rect">
                <a:avLst/>
              </a:prstGeom>
            </p:spPr>
          </p:pic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DCACD2CE-A34F-737C-2B42-175025D023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199" t="4423" r="4199" b="21731"/>
              <a:stretch/>
            </p:blipFill>
            <p:spPr>
              <a:xfrm>
                <a:off x="2154036" y="1096581"/>
                <a:ext cx="1028686" cy="1316735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2D890055-2689-76AB-359B-196E296835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000" t="7046" r="9111" b="24227"/>
              <a:stretch/>
            </p:blipFill>
            <p:spPr>
              <a:xfrm>
                <a:off x="3215597" y="1096543"/>
                <a:ext cx="1028701" cy="1316779"/>
              </a:xfrm>
              <a:prstGeom prst="rect">
                <a:avLst/>
              </a:prstGeom>
            </p:spPr>
          </p:pic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2657C4BA-8142-FF76-218A-3206006C1F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056" t="10000" r="5056" b="10000"/>
              <a:stretch/>
            </p:blipFill>
            <p:spPr>
              <a:xfrm>
                <a:off x="4277178" y="1096577"/>
                <a:ext cx="1028706" cy="1316736"/>
              </a:xfrm>
              <a:prstGeom prst="rect">
                <a:avLst/>
              </a:prstGeom>
            </p:spPr>
          </p:pic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3F930D24-94AE-D744-C98A-3140CE214A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556" t="8788" r="5556" b="13637"/>
              <a:stretch/>
            </p:blipFill>
            <p:spPr>
              <a:xfrm>
                <a:off x="5338764" y="1096591"/>
                <a:ext cx="1028688" cy="1316723"/>
              </a:xfrm>
              <a:prstGeom prst="rect">
                <a:avLst/>
              </a:prstGeom>
            </p:spPr>
          </p:pic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015D07B3-5DFC-9F3B-A481-F981917DD8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719" t="4764" r="5719" b="14816"/>
              <a:stretch/>
            </p:blipFill>
            <p:spPr>
              <a:xfrm>
                <a:off x="6400326" y="1096560"/>
                <a:ext cx="1028715" cy="1316754"/>
              </a:xfrm>
              <a:prstGeom prst="rect">
                <a:avLst/>
              </a:prstGeom>
            </p:spPr>
          </p:pic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2CE86A7E-A37F-75AD-32AF-1806717CC4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3964" t="13075" r="13964" b="13075"/>
              <a:stretch/>
            </p:blipFill>
            <p:spPr>
              <a:xfrm>
                <a:off x="30863" y="2448145"/>
                <a:ext cx="1028701" cy="1316804"/>
              </a:xfrm>
              <a:prstGeom prst="rect">
                <a:avLst/>
              </a:prstGeom>
            </p:spPr>
          </p:pic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747FAABF-1E5E-1B54-031F-8352CC3A12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11784" t="8355" r="11784" b="21506"/>
              <a:stretch/>
            </p:blipFill>
            <p:spPr>
              <a:xfrm>
                <a:off x="1086671" y="2448193"/>
                <a:ext cx="1028683" cy="1316775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BC83FD1C-5E48-32FD-DF51-725DFDC139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5391" t="5349" r="5391" b="15271"/>
              <a:stretch/>
            </p:blipFill>
            <p:spPr>
              <a:xfrm>
                <a:off x="2154037" y="2448140"/>
                <a:ext cx="1028683" cy="1316738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6465DBFC-14A4-F895-C56F-F2BFA3134A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8621" t="2500" r="8621" b="17500"/>
              <a:stretch/>
            </p:blipFill>
            <p:spPr>
              <a:xfrm>
                <a:off x="3209819" y="2448146"/>
                <a:ext cx="1028692" cy="1316736"/>
              </a:xfrm>
              <a:prstGeom prst="rect">
                <a:avLst/>
              </a:prstGeom>
            </p:spPr>
          </p:pic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173D981D-CC5E-AF83-6A44-68FA2E8E2E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10396" t="3548" r="10396" b="13870"/>
              <a:stretch/>
            </p:blipFill>
            <p:spPr>
              <a:xfrm>
                <a:off x="4277184" y="2448141"/>
                <a:ext cx="1028701" cy="1316756"/>
              </a:xfrm>
              <a:prstGeom prst="rect">
                <a:avLst/>
              </a:prstGeom>
            </p:spPr>
          </p:pic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ED51030F-2CAF-EC40-636C-D27F042A65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12597" t="6480" r="9480" b="11600"/>
              <a:stretch/>
            </p:blipFill>
            <p:spPr>
              <a:xfrm>
                <a:off x="5338728" y="2448146"/>
                <a:ext cx="1028713" cy="1316736"/>
              </a:xfrm>
              <a:prstGeom prst="rect">
                <a:avLst/>
              </a:prstGeom>
            </p:spPr>
          </p:pic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D4196045-8B3A-4BFB-C599-BE8F124F5D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11661" t="8375" r="11661" b="8375"/>
              <a:stretch/>
            </p:blipFill>
            <p:spPr>
              <a:xfrm>
                <a:off x="6400334" y="2448202"/>
                <a:ext cx="1028711" cy="1316705"/>
              </a:xfrm>
              <a:prstGeom prst="rect">
                <a:avLst/>
              </a:prstGeom>
            </p:spPr>
          </p:pic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EC533CA-FCB8-9C52-B5F2-3ED15B9ACC6C}"/>
              </a:ext>
            </a:extLst>
          </p:cNvPr>
          <p:cNvSpPr txBox="1"/>
          <p:nvPr/>
        </p:nvSpPr>
        <p:spPr>
          <a:xfrm>
            <a:off x="257080" y="239517"/>
            <a:ext cx="3522757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6</a:t>
            </a:r>
            <a:endParaRPr lang="he-IL" sz="2115" b="1" dirty="0"/>
          </a:p>
        </p:txBody>
      </p:sp>
    </p:spTree>
    <p:extLst>
      <p:ext uri="{BB962C8B-B14F-4D97-AF65-F5344CB8AC3E}">
        <p14:creationId xmlns:p14="http://schemas.microsoft.com/office/powerpoint/2010/main" val="31021691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51CD755-7F54-9F1C-4394-1F0C83AECE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933" y="2753179"/>
            <a:ext cx="6313805" cy="177990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9B8F766-A02F-6FDA-1921-ED488476B1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935" y="4895730"/>
            <a:ext cx="6313805" cy="9753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468B7FF-3561-8977-F729-EFF918B85C9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935" y="6305445"/>
            <a:ext cx="6313805" cy="1672590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B17464E4-5736-9C05-2CDF-FBDDF299D6D1}"/>
              </a:ext>
            </a:extLst>
          </p:cNvPr>
          <p:cNvCxnSpPr>
            <a:cxnSpLocks/>
          </p:cNvCxnSpPr>
          <p:nvPr/>
        </p:nvCxnSpPr>
        <p:spPr>
          <a:xfrm>
            <a:off x="622934" y="4654533"/>
            <a:ext cx="63138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D07CB66-5CA4-F303-468A-58BE64677020}"/>
              </a:ext>
            </a:extLst>
          </p:cNvPr>
          <p:cNvCxnSpPr>
            <a:cxnSpLocks/>
          </p:cNvCxnSpPr>
          <p:nvPr/>
        </p:nvCxnSpPr>
        <p:spPr>
          <a:xfrm>
            <a:off x="622933" y="6172468"/>
            <a:ext cx="63138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 Box 2">
            <a:extLst>
              <a:ext uri="{FF2B5EF4-FFF2-40B4-BE49-F238E27FC236}">
                <a16:creationId xmlns:a16="http://schemas.microsoft.com/office/drawing/2014/main" id="{E712D223-CEE2-9FE1-3998-24352BE8D1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2933" y="2604342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 Box 2">
            <a:extLst>
              <a:ext uri="{FF2B5EF4-FFF2-40B4-BE49-F238E27FC236}">
                <a16:creationId xmlns:a16="http://schemas.microsoft.com/office/drawing/2014/main" id="{B2BEFBA6-E2BF-47B8-1DBD-1099C6A795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2932" y="4691884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2">
            <a:extLst>
              <a:ext uri="{FF2B5EF4-FFF2-40B4-BE49-F238E27FC236}">
                <a16:creationId xmlns:a16="http://schemas.microsoft.com/office/drawing/2014/main" id="{1A8C9193-F226-7A5C-4CC2-3E5B84B673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636" y="6213593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0A9F5E7-DC3B-83B4-E8C6-C0032792A3C6}"/>
              </a:ext>
            </a:extLst>
          </p:cNvPr>
          <p:cNvSpPr txBox="1"/>
          <p:nvPr/>
        </p:nvSpPr>
        <p:spPr>
          <a:xfrm>
            <a:off x="257080" y="48678"/>
            <a:ext cx="3522757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7</a:t>
            </a:r>
            <a:endParaRPr lang="he-IL" sz="2115" b="1" dirty="0"/>
          </a:p>
        </p:txBody>
      </p:sp>
    </p:spTree>
    <p:extLst>
      <p:ext uri="{BB962C8B-B14F-4D97-AF65-F5344CB8AC3E}">
        <p14:creationId xmlns:p14="http://schemas.microsoft.com/office/powerpoint/2010/main" val="6489879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BC4366E-8FAF-9991-6549-8D63AF662895}"/>
              </a:ext>
            </a:extLst>
          </p:cNvPr>
          <p:cNvSpPr txBox="1"/>
          <p:nvPr/>
        </p:nvSpPr>
        <p:spPr>
          <a:xfrm>
            <a:off x="257080" y="239517"/>
            <a:ext cx="3522757" cy="4178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15" b="1" dirty="0"/>
              <a:t>Supplementary Figure S8</a:t>
            </a:r>
            <a:endParaRPr lang="he-IL" sz="2115" b="1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248C3E0D-B5F0-8CFB-9AB7-0AF3364060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7558220"/>
              </p:ext>
            </p:extLst>
          </p:nvPr>
        </p:nvGraphicFramePr>
        <p:xfrm>
          <a:off x="1695543" y="246456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FBB1F34-CC48-0726-C9E7-283EB74AD6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6587324"/>
              </p:ext>
            </p:extLst>
          </p:nvPr>
        </p:nvGraphicFramePr>
        <p:xfrm>
          <a:off x="1695543" y="614095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 Box 2">
            <a:extLst>
              <a:ext uri="{FF2B5EF4-FFF2-40B4-BE49-F238E27FC236}">
                <a16:creationId xmlns:a16="http://schemas.microsoft.com/office/drawing/2014/main" id="{06AAFA1B-6302-85D8-54B4-7E812F67AF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6955" y="2178818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 Box 2">
            <a:extLst>
              <a:ext uri="{FF2B5EF4-FFF2-40B4-BE49-F238E27FC236}">
                <a16:creationId xmlns:a16="http://schemas.microsoft.com/office/drawing/2014/main" id="{EADBFA4E-2D64-249B-5FA4-A993F3E7F8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6954" y="6077090"/>
            <a:ext cx="257175" cy="28575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867003-70CE-5B69-5FC7-E402F692BB15}"/>
              </a:ext>
            </a:extLst>
          </p:cNvPr>
          <p:cNvSpPr txBox="1"/>
          <p:nvPr/>
        </p:nvSpPr>
        <p:spPr>
          <a:xfrm>
            <a:off x="4587498" y="351333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AC5137E-89AF-1060-BD9E-F42A3A2653DB}"/>
              </a:ext>
            </a:extLst>
          </p:cNvPr>
          <p:cNvSpPr txBox="1"/>
          <p:nvPr/>
        </p:nvSpPr>
        <p:spPr>
          <a:xfrm>
            <a:off x="3502729" y="417717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/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4009192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236</TotalTime>
  <Words>394</Words>
  <Application>Microsoft Macintosh PowerPoint</Application>
  <PresentationFormat>Custom</PresentationFormat>
  <Paragraphs>13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Lev</dc:creator>
  <cp:lastModifiedBy>Dror Seliktar</cp:lastModifiedBy>
  <cp:revision>42</cp:revision>
  <cp:lastPrinted>2022-09-22T18:34:57Z</cp:lastPrinted>
  <dcterms:created xsi:type="dcterms:W3CDTF">2022-09-22T18:21:16Z</dcterms:created>
  <dcterms:modified xsi:type="dcterms:W3CDTF">2024-01-16T07:06:20Z</dcterms:modified>
</cp:coreProperties>
</file>